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76" r:id="rId3"/>
    <p:sldId id="294" r:id="rId4"/>
    <p:sldId id="277" r:id="rId5"/>
    <p:sldId id="278" r:id="rId6"/>
    <p:sldId id="279" r:id="rId7"/>
    <p:sldId id="281" r:id="rId8"/>
    <p:sldId id="270" r:id="rId9"/>
    <p:sldId id="291" r:id="rId10"/>
    <p:sldId id="292" r:id="rId11"/>
    <p:sldId id="293" r:id="rId12"/>
    <p:sldId id="295" r:id="rId13"/>
    <p:sldId id="296" r:id="rId14"/>
  </p:sldIdLst>
  <p:sldSz cx="9906000" cy="6858000" type="A4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102" d="100"/>
          <a:sy n="102" d="100"/>
        </p:scale>
        <p:origin x="-918" y="-96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Projects\PTM\Manuscript\to-Birgit\all-mod_res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Projects\PTM\Manuscript\to-Birgit\all-mod_res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Projects\PTM\Manuscript\to-Birgit\all-mod_res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Projects\PTM\Manuscript\to-Birgit\all-mod_res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Projects\PTM\Manuscript\REVIEW\modres-disprot-iupred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Projects\PTM\Manuscript\REVIEW\lipid-disprot-iupr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/>
              <a:t>Phosphoserine</a:t>
            </a:r>
          </a:p>
          <a:p>
            <a:pPr>
              <a:defRPr/>
            </a:pPr>
            <a:r>
              <a:rPr lang="en-US"/>
              <a:t>(av. accessibility = 0.47 </a:t>
            </a:r>
            <a:r>
              <a:rPr lang="en-US">
                <a:latin typeface="Calibri"/>
              </a:rPr>
              <a:t>±</a:t>
            </a:r>
            <a:r>
              <a:rPr lang="en-US"/>
              <a:t> 0.36)</a:t>
            </a:r>
          </a:p>
        </c:rich>
      </c:tx>
      <c:layout/>
      <c:overlay val="0"/>
    </c:title>
    <c:autoTitleDeleted val="0"/>
    <c:plotArea>
      <c:layout/>
      <c:pieChart>
        <c:varyColors val="1"/>
        <c:ser>
          <c:idx val="0"/>
          <c:order val="0"/>
          <c:tx>
            <c:strRef>
              <c:f>'extra-phospho'!$A$2</c:f>
              <c:strCache>
                <c:ptCount val="1"/>
                <c:pt idx="0">
                  <c:v>Phosphoserine</c:v>
                </c:pt>
              </c:strCache>
            </c:strRef>
          </c:tx>
          <c:dPt>
            <c:idx val="0"/>
            <c:bubble3D val="0"/>
            <c:spPr>
              <a:solidFill>
                <a:srgbClr val="0070C0"/>
              </a:solidFill>
            </c:spPr>
          </c:dPt>
          <c:dPt>
            <c:idx val="1"/>
            <c:bubble3D val="0"/>
            <c:spPr>
              <a:solidFill>
                <a:srgbClr val="0070C0">
                  <a:alpha val="50000"/>
                </a:srgbClr>
              </a:solidFill>
            </c:spPr>
          </c:dPt>
          <c:dPt>
            <c:idx val="2"/>
            <c:bubble3D val="0"/>
            <c:spPr>
              <a:solidFill>
                <a:srgbClr val="00B050"/>
              </a:solidFill>
            </c:spPr>
          </c:dPt>
          <c:dPt>
            <c:idx val="3"/>
            <c:bubble3D val="0"/>
            <c:spPr>
              <a:solidFill>
                <a:srgbClr val="00B050">
                  <a:alpha val="50000"/>
                </a:srgbClr>
              </a:solidFill>
            </c:spPr>
          </c:dPt>
          <c:dPt>
            <c:idx val="4"/>
            <c:bubble3D val="0"/>
            <c:spPr>
              <a:solidFill>
                <a:srgbClr val="FFFF00"/>
              </a:solidFill>
            </c:spPr>
          </c:dPt>
          <c:dPt>
            <c:idx val="5"/>
            <c:bubble3D val="0"/>
            <c:spPr>
              <a:solidFill>
                <a:srgbClr val="FFFF00">
                  <a:alpha val="50000"/>
                </a:srgbClr>
              </a:solidFill>
            </c:spPr>
          </c:dPt>
          <c:dPt>
            <c:idx val="6"/>
            <c:bubble3D val="0"/>
            <c:spPr>
              <a:solidFill>
                <a:srgbClr val="C00000"/>
              </a:solidFill>
            </c:spPr>
          </c:dPt>
          <c:dPt>
            <c:idx val="7"/>
            <c:bubble3D val="0"/>
            <c:spPr>
              <a:solidFill>
                <a:srgbClr val="C00000">
                  <a:alpha val="50000"/>
                </a:srgbClr>
              </a:solidFill>
            </c:spPr>
          </c:dPt>
          <c:dLbls>
            <c:showLegendKey val="0"/>
            <c:showVal val="1"/>
            <c:showCatName val="0"/>
            <c:showSerName val="0"/>
            <c:showPercent val="0"/>
            <c:showBubbleSize val="0"/>
            <c:showLeaderLines val="1"/>
          </c:dLbls>
          <c:cat>
            <c:strRef>
              <c:f>'extra-phospho'!$B$1:$I$1</c:f>
              <c:strCache>
                <c:ptCount val="8"/>
                <c:pt idx="0">
                  <c:v>STRUCTURE-SAME</c:v>
                </c:pt>
                <c:pt idx="1">
                  <c:v>PD-STRUCTURE-SAME</c:v>
                </c:pt>
                <c:pt idx="2">
                  <c:v>STRUCTURE-DIFF</c:v>
                </c:pt>
                <c:pt idx="3">
                  <c:v>PD-STRUCTURE-DIFF</c:v>
                </c:pt>
                <c:pt idx="4">
                  <c:v>DISORDER</c:v>
                </c:pt>
                <c:pt idx="5">
                  <c:v>PD-DISORDER</c:v>
                </c:pt>
                <c:pt idx="6">
                  <c:v>TRUE-UNKNOWN</c:v>
                </c:pt>
                <c:pt idx="7">
                  <c:v>PD-TRUE-UNKNOWN</c:v>
                </c:pt>
              </c:strCache>
            </c:strRef>
          </c:cat>
          <c:val>
            <c:numRef>
              <c:f>'extra-phospho'!$B$2:$I$2</c:f>
              <c:numCache>
                <c:formatCode>General</c:formatCode>
                <c:ptCount val="8"/>
                <c:pt idx="0">
                  <c:v>9014</c:v>
                </c:pt>
                <c:pt idx="1">
                  <c:v>2584</c:v>
                </c:pt>
                <c:pt idx="2">
                  <c:v>1993</c:v>
                </c:pt>
                <c:pt idx="3">
                  <c:v>1255</c:v>
                </c:pt>
                <c:pt idx="4">
                  <c:v>1863</c:v>
                </c:pt>
                <c:pt idx="5">
                  <c:v>2626</c:v>
                </c:pt>
                <c:pt idx="6">
                  <c:v>14346</c:v>
                </c:pt>
                <c:pt idx="7">
                  <c:v>403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layout/>
      <c:overlay val="0"/>
      <c:txPr>
        <a:bodyPr/>
        <a:lstStyle/>
        <a:p>
          <a:pPr>
            <a:defRPr i="1"/>
          </a:pPr>
          <a:endParaRPr lang="de-DE"/>
        </a:p>
      </c:txPr>
    </c:legend>
    <c:plotVisOnly val="1"/>
    <c:dispBlanksAs val="zero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Phosphothreonine</a:t>
            </a:r>
          </a:p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 i="0" baseline="0"/>
              <a:t>(av. accessibility = 0.39 ± 0.30)</a:t>
            </a:r>
            <a:endParaRPr lang="en-US"/>
          </a:p>
        </c:rich>
      </c:tx>
      <c:layout/>
      <c:overlay val="0"/>
    </c:title>
    <c:autoTitleDeleted val="0"/>
    <c:plotArea>
      <c:layout/>
      <c:pieChart>
        <c:varyColors val="1"/>
        <c:ser>
          <c:idx val="1"/>
          <c:order val="0"/>
          <c:tx>
            <c:strRef>
              <c:f>'extra-phospho'!$A$3</c:f>
              <c:strCache>
                <c:ptCount val="1"/>
                <c:pt idx="0">
                  <c:v>Phosphothreonine</c:v>
                </c:pt>
              </c:strCache>
            </c:strRef>
          </c:tx>
          <c:dPt>
            <c:idx val="0"/>
            <c:bubble3D val="0"/>
            <c:spPr>
              <a:solidFill>
                <a:srgbClr val="0070C0"/>
              </a:solidFill>
            </c:spPr>
          </c:dPt>
          <c:dPt>
            <c:idx val="1"/>
            <c:bubble3D val="0"/>
            <c:spPr>
              <a:solidFill>
                <a:srgbClr val="0070C0">
                  <a:alpha val="50000"/>
                </a:srgbClr>
              </a:solidFill>
            </c:spPr>
          </c:dPt>
          <c:dPt>
            <c:idx val="2"/>
            <c:bubble3D val="0"/>
            <c:spPr>
              <a:solidFill>
                <a:srgbClr val="00B050"/>
              </a:solidFill>
            </c:spPr>
          </c:dPt>
          <c:dPt>
            <c:idx val="3"/>
            <c:bubble3D val="0"/>
            <c:spPr>
              <a:solidFill>
                <a:srgbClr val="00B050">
                  <a:alpha val="50000"/>
                </a:srgbClr>
              </a:solidFill>
            </c:spPr>
          </c:dPt>
          <c:dPt>
            <c:idx val="4"/>
            <c:bubble3D val="0"/>
            <c:spPr>
              <a:solidFill>
                <a:srgbClr val="FFFF00"/>
              </a:solidFill>
            </c:spPr>
          </c:dPt>
          <c:dPt>
            <c:idx val="5"/>
            <c:bubble3D val="0"/>
            <c:spPr>
              <a:solidFill>
                <a:srgbClr val="FFFF00">
                  <a:alpha val="50000"/>
                </a:srgbClr>
              </a:solidFill>
            </c:spPr>
          </c:dPt>
          <c:dPt>
            <c:idx val="6"/>
            <c:bubble3D val="0"/>
            <c:spPr>
              <a:solidFill>
                <a:srgbClr val="C00000"/>
              </a:solidFill>
            </c:spPr>
          </c:dPt>
          <c:dPt>
            <c:idx val="7"/>
            <c:bubble3D val="0"/>
            <c:spPr>
              <a:solidFill>
                <a:srgbClr val="C00000">
                  <a:alpha val="50000"/>
                </a:srgbClr>
              </a:solidFill>
            </c:spPr>
          </c:dPt>
          <c:dLbls>
            <c:showLegendKey val="0"/>
            <c:showVal val="1"/>
            <c:showCatName val="0"/>
            <c:showSerName val="0"/>
            <c:showPercent val="0"/>
            <c:showBubbleSize val="0"/>
            <c:showLeaderLines val="1"/>
          </c:dLbls>
          <c:cat>
            <c:strRef>
              <c:f>'extra-phospho'!$B$1:$I$1</c:f>
              <c:strCache>
                <c:ptCount val="8"/>
                <c:pt idx="0">
                  <c:v>STRUCTURE-SAME</c:v>
                </c:pt>
                <c:pt idx="1">
                  <c:v>PD-STRUCTURE-SAME</c:v>
                </c:pt>
                <c:pt idx="2">
                  <c:v>STRUCTURE-DIFF</c:v>
                </c:pt>
                <c:pt idx="3">
                  <c:v>PD-STRUCTURE-DIFF</c:v>
                </c:pt>
                <c:pt idx="4">
                  <c:v>DISORDER</c:v>
                </c:pt>
                <c:pt idx="5">
                  <c:v>PD-DISORDER</c:v>
                </c:pt>
                <c:pt idx="6">
                  <c:v>TRUE-UNKNOWN</c:v>
                </c:pt>
                <c:pt idx="7">
                  <c:v>PD-TRUE-UNKNOWN</c:v>
                </c:pt>
              </c:strCache>
            </c:strRef>
          </c:cat>
          <c:val>
            <c:numRef>
              <c:f>'extra-phospho'!$B$3:$I$3</c:f>
              <c:numCache>
                <c:formatCode>General</c:formatCode>
                <c:ptCount val="8"/>
                <c:pt idx="0">
                  <c:v>4571</c:v>
                </c:pt>
                <c:pt idx="1">
                  <c:v>867</c:v>
                </c:pt>
                <c:pt idx="2">
                  <c:v>476</c:v>
                </c:pt>
                <c:pt idx="3">
                  <c:v>238</c:v>
                </c:pt>
                <c:pt idx="4">
                  <c:v>757</c:v>
                </c:pt>
                <c:pt idx="5">
                  <c:v>646</c:v>
                </c:pt>
                <c:pt idx="6">
                  <c:v>2361</c:v>
                </c:pt>
                <c:pt idx="7">
                  <c:v>72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layout/>
      <c:overlay val="0"/>
      <c:txPr>
        <a:bodyPr/>
        <a:lstStyle/>
        <a:p>
          <a:pPr>
            <a:defRPr i="1"/>
          </a:pPr>
          <a:endParaRPr lang="de-DE"/>
        </a:p>
      </c:txPr>
    </c:legend>
    <c:plotVisOnly val="1"/>
    <c:dispBlanksAs val="zero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Phosphotyrosine</a:t>
            </a:r>
          </a:p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 i="0" baseline="0"/>
              <a:t>(av. accessibility = 0.30 ± 0.25)</a:t>
            </a:r>
            <a:endParaRPr lang="en-US"/>
          </a:p>
        </c:rich>
      </c:tx>
      <c:layout/>
      <c:overlay val="0"/>
    </c:title>
    <c:autoTitleDeleted val="0"/>
    <c:plotArea>
      <c:layout/>
      <c:pieChart>
        <c:varyColors val="1"/>
        <c:ser>
          <c:idx val="1"/>
          <c:order val="0"/>
          <c:tx>
            <c:strRef>
              <c:f>'extra-phospho'!$A$5</c:f>
              <c:strCache>
                <c:ptCount val="1"/>
                <c:pt idx="0">
                  <c:v>Phosphotyrosine</c:v>
                </c:pt>
              </c:strCache>
            </c:strRef>
          </c:tx>
          <c:dPt>
            <c:idx val="0"/>
            <c:bubble3D val="0"/>
            <c:spPr>
              <a:solidFill>
                <a:srgbClr val="0070C0"/>
              </a:solidFill>
            </c:spPr>
          </c:dPt>
          <c:dPt>
            <c:idx val="1"/>
            <c:bubble3D val="0"/>
            <c:spPr>
              <a:solidFill>
                <a:srgbClr val="0070C0">
                  <a:alpha val="50000"/>
                </a:srgbClr>
              </a:solidFill>
            </c:spPr>
          </c:dPt>
          <c:dPt>
            <c:idx val="2"/>
            <c:bubble3D val="0"/>
            <c:spPr>
              <a:solidFill>
                <a:srgbClr val="00B050"/>
              </a:solidFill>
            </c:spPr>
          </c:dPt>
          <c:dPt>
            <c:idx val="3"/>
            <c:bubble3D val="0"/>
            <c:spPr>
              <a:solidFill>
                <a:srgbClr val="00B050">
                  <a:alpha val="50000"/>
                </a:srgbClr>
              </a:solidFill>
            </c:spPr>
          </c:dPt>
          <c:dPt>
            <c:idx val="4"/>
            <c:bubble3D val="0"/>
            <c:spPr>
              <a:solidFill>
                <a:srgbClr val="FFFF00"/>
              </a:solidFill>
            </c:spPr>
          </c:dPt>
          <c:dPt>
            <c:idx val="5"/>
            <c:bubble3D val="0"/>
            <c:spPr>
              <a:solidFill>
                <a:srgbClr val="FFFF00">
                  <a:alpha val="50000"/>
                </a:srgbClr>
              </a:solidFill>
            </c:spPr>
          </c:dPt>
          <c:dPt>
            <c:idx val="6"/>
            <c:bubble3D val="0"/>
            <c:spPr>
              <a:solidFill>
                <a:srgbClr val="C00000"/>
              </a:solidFill>
            </c:spPr>
          </c:dPt>
          <c:dPt>
            <c:idx val="7"/>
            <c:bubble3D val="0"/>
            <c:spPr>
              <a:solidFill>
                <a:srgbClr val="C00000">
                  <a:alpha val="50000"/>
                </a:srgbClr>
              </a:solidFill>
            </c:spPr>
          </c:dPt>
          <c:dLbls>
            <c:showLegendKey val="0"/>
            <c:showVal val="1"/>
            <c:showCatName val="0"/>
            <c:showSerName val="0"/>
            <c:showPercent val="0"/>
            <c:showBubbleSize val="0"/>
            <c:showLeaderLines val="1"/>
          </c:dLbls>
          <c:cat>
            <c:strRef>
              <c:f>'extra-phospho'!$B$1:$I$1</c:f>
              <c:strCache>
                <c:ptCount val="8"/>
                <c:pt idx="0">
                  <c:v>STRUCTURE-SAME</c:v>
                </c:pt>
                <c:pt idx="1">
                  <c:v>PD-STRUCTURE-SAME</c:v>
                </c:pt>
                <c:pt idx="2">
                  <c:v>STRUCTURE-DIFF</c:v>
                </c:pt>
                <c:pt idx="3">
                  <c:v>PD-STRUCTURE-DIFF</c:v>
                </c:pt>
                <c:pt idx="4">
                  <c:v>DISORDER</c:v>
                </c:pt>
                <c:pt idx="5">
                  <c:v>PD-DISORDER</c:v>
                </c:pt>
                <c:pt idx="6">
                  <c:v>TRUE-UNKNOWN</c:v>
                </c:pt>
                <c:pt idx="7">
                  <c:v>PD-TRUE-UNKNOWN</c:v>
                </c:pt>
              </c:strCache>
            </c:strRef>
          </c:cat>
          <c:val>
            <c:numRef>
              <c:f>'extra-phospho'!$B$5:$I$5</c:f>
              <c:numCache>
                <c:formatCode>General</c:formatCode>
                <c:ptCount val="8"/>
                <c:pt idx="0">
                  <c:v>4665</c:v>
                </c:pt>
                <c:pt idx="1">
                  <c:v>223</c:v>
                </c:pt>
                <c:pt idx="2">
                  <c:v>326</c:v>
                </c:pt>
                <c:pt idx="3">
                  <c:v>21</c:v>
                </c:pt>
                <c:pt idx="4">
                  <c:v>315</c:v>
                </c:pt>
                <c:pt idx="5">
                  <c:v>143</c:v>
                </c:pt>
                <c:pt idx="6">
                  <c:v>1848</c:v>
                </c:pt>
                <c:pt idx="7">
                  <c:v>14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layout/>
      <c:overlay val="0"/>
      <c:txPr>
        <a:bodyPr/>
        <a:lstStyle/>
        <a:p>
          <a:pPr>
            <a:defRPr i="1"/>
          </a:pPr>
          <a:endParaRPr lang="de-DE"/>
        </a:p>
      </c:txPr>
    </c:legend>
    <c:plotVisOnly val="1"/>
    <c:dispBlanksAs val="zero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Phosphohistidine</a:t>
            </a:r>
          </a:p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 i="0" baseline="0"/>
              <a:t>(av. accessibility = 0.31 ± 0.16)</a:t>
            </a:r>
            <a:endParaRPr lang="en-US"/>
          </a:p>
        </c:rich>
      </c:tx>
      <c:layout/>
      <c:overlay val="0"/>
    </c:title>
    <c:autoTitleDeleted val="0"/>
    <c:plotArea>
      <c:layout/>
      <c:pieChart>
        <c:varyColors val="1"/>
        <c:ser>
          <c:idx val="1"/>
          <c:order val="0"/>
          <c:tx>
            <c:strRef>
              <c:f>'extra-phospho'!$A$28</c:f>
              <c:strCache>
                <c:ptCount val="1"/>
                <c:pt idx="0">
                  <c:v>Phosphohistidine</c:v>
                </c:pt>
              </c:strCache>
            </c:strRef>
          </c:tx>
          <c:dPt>
            <c:idx val="0"/>
            <c:bubble3D val="0"/>
            <c:spPr>
              <a:solidFill>
                <a:srgbClr val="0070C0"/>
              </a:solidFill>
            </c:spPr>
          </c:dPt>
          <c:dPt>
            <c:idx val="1"/>
            <c:bubble3D val="0"/>
            <c:spPr>
              <a:solidFill>
                <a:srgbClr val="0070C0">
                  <a:alpha val="50000"/>
                </a:srgbClr>
              </a:solidFill>
            </c:spPr>
          </c:dPt>
          <c:dPt>
            <c:idx val="2"/>
            <c:bubble3D val="0"/>
            <c:spPr>
              <a:solidFill>
                <a:srgbClr val="00B050"/>
              </a:solidFill>
            </c:spPr>
          </c:dPt>
          <c:dPt>
            <c:idx val="3"/>
            <c:bubble3D val="0"/>
            <c:spPr>
              <a:solidFill>
                <a:srgbClr val="00B050">
                  <a:alpha val="50000"/>
                </a:srgbClr>
              </a:solidFill>
            </c:spPr>
          </c:dPt>
          <c:dPt>
            <c:idx val="4"/>
            <c:bubble3D val="0"/>
            <c:spPr>
              <a:solidFill>
                <a:srgbClr val="FFFF00"/>
              </a:solidFill>
            </c:spPr>
          </c:dPt>
          <c:dPt>
            <c:idx val="5"/>
            <c:bubble3D val="0"/>
            <c:spPr>
              <a:solidFill>
                <a:srgbClr val="FFFF00">
                  <a:alpha val="50000"/>
                </a:srgbClr>
              </a:solidFill>
            </c:spPr>
          </c:dPt>
          <c:dPt>
            <c:idx val="6"/>
            <c:bubble3D val="0"/>
            <c:spPr>
              <a:solidFill>
                <a:srgbClr val="C00000"/>
              </a:solidFill>
            </c:spPr>
          </c:dPt>
          <c:dPt>
            <c:idx val="7"/>
            <c:bubble3D val="0"/>
            <c:spPr>
              <a:solidFill>
                <a:srgbClr val="C00000">
                  <a:alpha val="50000"/>
                </a:srgbClr>
              </a:solidFill>
            </c:spPr>
          </c:dPt>
          <c:dLbls>
            <c:showLegendKey val="0"/>
            <c:showVal val="1"/>
            <c:showCatName val="0"/>
            <c:showSerName val="0"/>
            <c:showPercent val="0"/>
            <c:showBubbleSize val="0"/>
            <c:showLeaderLines val="1"/>
          </c:dLbls>
          <c:cat>
            <c:strRef>
              <c:f>'extra-phospho'!$B$1:$I$1</c:f>
              <c:strCache>
                <c:ptCount val="8"/>
                <c:pt idx="0">
                  <c:v>STRUCTURE-SAME</c:v>
                </c:pt>
                <c:pt idx="1">
                  <c:v>PD-STRUCTURE-SAME</c:v>
                </c:pt>
                <c:pt idx="2">
                  <c:v>STRUCTURE-DIFF</c:v>
                </c:pt>
                <c:pt idx="3">
                  <c:v>PD-STRUCTURE-DIFF</c:v>
                </c:pt>
                <c:pt idx="4">
                  <c:v>DISORDER</c:v>
                </c:pt>
                <c:pt idx="5">
                  <c:v>PD-DISORDER</c:v>
                </c:pt>
                <c:pt idx="6">
                  <c:v>TRUE-UNKNOWN</c:v>
                </c:pt>
                <c:pt idx="7">
                  <c:v>PD-TRUE-UNKNOWN</c:v>
                </c:pt>
              </c:strCache>
            </c:strRef>
          </c:cat>
          <c:val>
            <c:numRef>
              <c:f>'extra-phospho'!$B$28:$I$28</c:f>
              <c:numCache>
                <c:formatCode>General</c:formatCode>
                <c:ptCount val="8"/>
                <c:pt idx="0">
                  <c:v>496</c:v>
                </c:pt>
                <c:pt idx="1">
                  <c:v>0</c:v>
                </c:pt>
                <c:pt idx="2">
                  <c:v>17</c:v>
                </c:pt>
                <c:pt idx="3">
                  <c:v>1</c:v>
                </c:pt>
                <c:pt idx="4">
                  <c:v>14</c:v>
                </c:pt>
                <c:pt idx="5">
                  <c:v>0</c:v>
                </c:pt>
                <c:pt idx="6">
                  <c:v>73</c:v>
                </c:pt>
                <c:pt idx="7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legend>
      <c:legendPos val="r"/>
      <c:layout/>
      <c:overlay val="0"/>
      <c:txPr>
        <a:bodyPr/>
        <a:lstStyle/>
        <a:p>
          <a:pPr>
            <a:defRPr i="1"/>
          </a:pPr>
          <a:endParaRPr lang="de-DE"/>
        </a:p>
      </c:txPr>
    </c:legend>
    <c:plotVisOnly val="1"/>
    <c:dispBlanksAs val="zero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800" b="1" i="0" baseline="0"/>
              <a:t>MOD_RES (positive score, low accessibility, freq &gt; 100)</a:t>
            </a:r>
            <a:endParaRPr lang="en-US"/>
          </a:p>
        </c:rich>
      </c:tx>
      <c:layout/>
      <c:overlay val="0"/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buried (2)'!$B$1</c:f>
              <c:strCache>
                <c:ptCount val="1"/>
                <c:pt idx="0">
                  <c:v>% DisProt</c:v>
                </c:pt>
              </c:strCache>
            </c:strRef>
          </c:tx>
          <c:spPr>
            <a:solidFill>
              <a:srgbClr val="FF0000"/>
            </a:solidFill>
            <a:ln w="12700">
              <a:solidFill>
                <a:srgbClr val="FF0000"/>
              </a:solidFill>
              <a:prstDash val="solid"/>
            </a:ln>
          </c:spPr>
          <c:invertIfNegative val="0"/>
          <c:cat>
            <c:strRef>
              <c:f>'buried (2)'!$Z$2:$Z$16</c:f>
              <c:strCache>
                <c:ptCount val="15"/>
                <c:pt idx="0">
                  <c:v>Phosphotyrosine (0.09)</c:v>
                </c:pt>
                <c:pt idx="1">
                  <c:v>N6-(pyridoxal phosphate)lysine (0.96)</c:v>
                </c:pt>
                <c:pt idx="2">
                  <c:v>N6-carboxylysine (0.88)</c:v>
                </c:pt>
                <c:pt idx="3">
                  <c:v>4-aspartylphosphate (0.85)</c:v>
                </c:pt>
                <c:pt idx="4">
                  <c:v>3-methylthioaspartic acid (1)</c:v>
                </c:pt>
                <c:pt idx="5">
                  <c:v>Phosphohistidine (0.65)</c:v>
                </c:pt>
                <c:pt idx="6">
                  <c:v>Nitrated tyrosine (0.69)</c:v>
                </c:pt>
                <c:pt idx="7">
                  <c:v>S-nitrosocysteine (0.8)</c:v>
                </c:pt>
                <c:pt idx="8">
                  <c:v>N6-(retinylidene)lysine (1)</c:v>
                </c:pt>
                <c:pt idx="9">
                  <c:v>Methionine sulfoxide (0.99)</c:v>
                </c:pt>
                <c:pt idx="10">
                  <c:v>N6-(3,6-diaminohexanoyl)-5-hydroxylysine (1)</c:v>
                </c:pt>
                <c:pt idx="11">
                  <c:v>5-glutamyl glycerylphosphorylethanolamine (1)</c:v>
                </c:pt>
                <c:pt idx="12">
                  <c:v>Glycine radical (0.93)</c:v>
                </c:pt>
                <c:pt idx="13">
                  <c:v>Cysteine sulfenic acid (-SOH) (1)</c:v>
                </c:pt>
                <c:pt idx="14">
                  <c:v>N4-methylasparagine (0.96)</c:v>
                </c:pt>
              </c:strCache>
            </c:strRef>
          </c:cat>
          <c:val>
            <c:numRef>
              <c:f>'buried (2)'!$B$2:$B$16</c:f>
              <c:numCache>
                <c:formatCode>General</c:formatCode>
                <c:ptCount val="15"/>
                <c:pt idx="0">
                  <c:v>3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0</c:v>
                </c:pt>
                <c:pt idx="6">
                  <c:v>1</c:v>
                </c:pt>
                <c:pt idx="7">
                  <c:v>3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</c:numCache>
            </c:numRef>
          </c:val>
        </c:ser>
        <c:ser>
          <c:idx val="1"/>
          <c:order val="1"/>
          <c:tx>
            <c:strRef>
              <c:f>'buried (2)'!$C$1</c:f>
              <c:strCache>
                <c:ptCount val="1"/>
                <c:pt idx="0">
                  <c:v>% IUPred</c:v>
                </c:pt>
              </c:strCache>
            </c:strRef>
          </c:tx>
          <c:spPr>
            <a:solidFill>
              <a:srgbClr val="0070C0"/>
            </a:solidFill>
            <a:ln w="12700">
              <a:solidFill>
                <a:schemeClr val="accent1"/>
              </a:solidFill>
            </a:ln>
          </c:spPr>
          <c:invertIfNegative val="0"/>
          <c:cat>
            <c:strRef>
              <c:f>'buried (2)'!$Z$2:$Z$16</c:f>
              <c:strCache>
                <c:ptCount val="15"/>
                <c:pt idx="0">
                  <c:v>Phosphotyrosine (0.09)</c:v>
                </c:pt>
                <c:pt idx="1">
                  <c:v>N6-(pyridoxal phosphate)lysine (0.96)</c:v>
                </c:pt>
                <c:pt idx="2">
                  <c:v>N6-carboxylysine (0.88)</c:v>
                </c:pt>
                <c:pt idx="3">
                  <c:v>4-aspartylphosphate (0.85)</c:v>
                </c:pt>
                <c:pt idx="4">
                  <c:v>3-methylthioaspartic acid (1)</c:v>
                </c:pt>
                <c:pt idx="5">
                  <c:v>Phosphohistidine (0.65)</c:v>
                </c:pt>
                <c:pt idx="6">
                  <c:v>Nitrated tyrosine (0.69)</c:v>
                </c:pt>
                <c:pt idx="7">
                  <c:v>S-nitrosocysteine (0.8)</c:v>
                </c:pt>
                <c:pt idx="8">
                  <c:v>N6-(retinylidene)lysine (1)</c:v>
                </c:pt>
                <c:pt idx="9">
                  <c:v>Methionine sulfoxide (0.99)</c:v>
                </c:pt>
                <c:pt idx="10">
                  <c:v>N6-(3,6-diaminohexanoyl)-5-hydroxylysine (1)</c:v>
                </c:pt>
                <c:pt idx="11">
                  <c:v>5-glutamyl glycerylphosphorylethanolamine (1)</c:v>
                </c:pt>
                <c:pt idx="12">
                  <c:v>Glycine radical (0.93)</c:v>
                </c:pt>
                <c:pt idx="13">
                  <c:v>Cysteine sulfenic acid (-SOH) (1)</c:v>
                </c:pt>
                <c:pt idx="14">
                  <c:v>N4-methylasparagine (0.96)</c:v>
                </c:pt>
              </c:strCache>
            </c:strRef>
          </c:cat>
          <c:val>
            <c:numRef>
              <c:f>'buried (2)'!$C$2:$C$16</c:f>
              <c:numCache>
                <c:formatCode>General</c:formatCode>
                <c:ptCount val="15"/>
                <c:pt idx="0">
                  <c:v>1795</c:v>
                </c:pt>
                <c:pt idx="1">
                  <c:v>5</c:v>
                </c:pt>
                <c:pt idx="2">
                  <c:v>2</c:v>
                </c:pt>
                <c:pt idx="3">
                  <c:v>3</c:v>
                </c:pt>
                <c:pt idx="4">
                  <c:v>0</c:v>
                </c:pt>
                <c:pt idx="5">
                  <c:v>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8</c:v>
                </c:pt>
                <c:pt idx="10">
                  <c:v>0</c:v>
                </c:pt>
                <c:pt idx="11">
                  <c:v>5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</c:numCache>
            </c:numRef>
          </c:val>
        </c:ser>
        <c:ser>
          <c:idx val="2"/>
          <c:order val="2"/>
          <c:tx>
            <c:strRef>
              <c:f>'buried (2)'!$F$1</c:f>
              <c:strCache>
                <c:ptCount val="1"/>
                <c:pt idx="0">
                  <c:v>% Both</c:v>
                </c:pt>
              </c:strCache>
            </c:strRef>
          </c:tx>
          <c:spPr>
            <a:solidFill>
              <a:srgbClr val="00B050"/>
            </a:solidFill>
            <a:ln w="12700">
              <a:solidFill>
                <a:srgbClr val="00B050"/>
              </a:solidFill>
            </a:ln>
          </c:spPr>
          <c:invertIfNegative val="0"/>
          <c:cat>
            <c:strRef>
              <c:f>'buried (2)'!$Z$2:$Z$16</c:f>
              <c:strCache>
                <c:ptCount val="15"/>
                <c:pt idx="0">
                  <c:v>Phosphotyrosine (0.09)</c:v>
                </c:pt>
                <c:pt idx="1">
                  <c:v>N6-(pyridoxal phosphate)lysine (0.96)</c:v>
                </c:pt>
                <c:pt idx="2">
                  <c:v>N6-carboxylysine (0.88)</c:v>
                </c:pt>
                <c:pt idx="3">
                  <c:v>4-aspartylphosphate (0.85)</c:v>
                </c:pt>
                <c:pt idx="4">
                  <c:v>3-methylthioaspartic acid (1)</c:v>
                </c:pt>
                <c:pt idx="5">
                  <c:v>Phosphohistidine (0.65)</c:v>
                </c:pt>
                <c:pt idx="6">
                  <c:v>Nitrated tyrosine (0.69)</c:v>
                </c:pt>
                <c:pt idx="7">
                  <c:v>S-nitrosocysteine (0.8)</c:v>
                </c:pt>
                <c:pt idx="8">
                  <c:v>N6-(retinylidene)lysine (1)</c:v>
                </c:pt>
                <c:pt idx="9">
                  <c:v>Methionine sulfoxide (0.99)</c:v>
                </c:pt>
                <c:pt idx="10">
                  <c:v>N6-(3,6-diaminohexanoyl)-5-hydroxylysine (1)</c:v>
                </c:pt>
                <c:pt idx="11">
                  <c:v>5-glutamyl glycerylphosphorylethanolamine (1)</c:v>
                </c:pt>
                <c:pt idx="12">
                  <c:v>Glycine radical (0.93)</c:v>
                </c:pt>
                <c:pt idx="13">
                  <c:v>Cysteine sulfenic acid (-SOH) (1)</c:v>
                </c:pt>
                <c:pt idx="14">
                  <c:v>N4-methylasparagine (0.96)</c:v>
                </c:pt>
              </c:strCache>
            </c:strRef>
          </c:cat>
          <c:val>
            <c:numRef>
              <c:f>'buried (2)'!$F$2:$F$16</c:f>
              <c:numCache>
                <c:formatCode>General</c:formatCode>
                <c:ptCount val="15"/>
                <c:pt idx="0">
                  <c:v>2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</c:numCache>
            </c:numRef>
          </c:val>
        </c:ser>
        <c:ser>
          <c:idx val="4"/>
          <c:order val="4"/>
          <c:tx>
            <c:strRef>
              <c:f>'buried (2)'!$G$1</c:f>
              <c:strCache>
                <c:ptCount val="1"/>
                <c:pt idx="0">
                  <c:v>% Other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</c:spPr>
          <c:invertIfNegative val="0"/>
          <c:cat>
            <c:strRef>
              <c:f>'buried (2)'!$Z$2:$Z$16</c:f>
              <c:strCache>
                <c:ptCount val="15"/>
                <c:pt idx="0">
                  <c:v>Phosphotyrosine (0.09)</c:v>
                </c:pt>
                <c:pt idx="1">
                  <c:v>N6-(pyridoxal phosphate)lysine (0.96)</c:v>
                </c:pt>
                <c:pt idx="2">
                  <c:v>N6-carboxylysine (0.88)</c:v>
                </c:pt>
                <c:pt idx="3">
                  <c:v>4-aspartylphosphate (0.85)</c:v>
                </c:pt>
                <c:pt idx="4">
                  <c:v>3-methylthioaspartic acid (1)</c:v>
                </c:pt>
                <c:pt idx="5">
                  <c:v>Phosphohistidine (0.65)</c:v>
                </c:pt>
                <c:pt idx="6">
                  <c:v>Nitrated tyrosine (0.69)</c:v>
                </c:pt>
                <c:pt idx="7">
                  <c:v>S-nitrosocysteine (0.8)</c:v>
                </c:pt>
                <c:pt idx="8">
                  <c:v>N6-(retinylidene)lysine (1)</c:v>
                </c:pt>
                <c:pt idx="9">
                  <c:v>Methionine sulfoxide (0.99)</c:v>
                </c:pt>
                <c:pt idx="10">
                  <c:v>N6-(3,6-diaminohexanoyl)-5-hydroxylysine (1)</c:v>
                </c:pt>
                <c:pt idx="11">
                  <c:v>5-glutamyl glycerylphosphorylethanolamine (1)</c:v>
                </c:pt>
                <c:pt idx="12">
                  <c:v>Glycine radical (0.93)</c:v>
                </c:pt>
                <c:pt idx="13">
                  <c:v>Cysteine sulfenic acid (-SOH) (1)</c:v>
                </c:pt>
                <c:pt idx="14">
                  <c:v>N4-methylasparagine (0.96)</c:v>
                </c:pt>
              </c:strCache>
            </c:strRef>
          </c:cat>
          <c:val>
            <c:numRef>
              <c:f>'buried (2)'!$G$2:$G$16</c:f>
              <c:numCache>
                <c:formatCode>General</c:formatCode>
                <c:ptCount val="15"/>
                <c:pt idx="0">
                  <c:v>7123</c:v>
                </c:pt>
                <c:pt idx="1">
                  <c:v>6438</c:v>
                </c:pt>
                <c:pt idx="2">
                  <c:v>1598</c:v>
                </c:pt>
                <c:pt idx="3">
                  <c:v>924</c:v>
                </c:pt>
                <c:pt idx="4">
                  <c:v>742</c:v>
                </c:pt>
                <c:pt idx="5">
                  <c:v>600</c:v>
                </c:pt>
                <c:pt idx="6">
                  <c:v>324</c:v>
                </c:pt>
                <c:pt idx="7">
                  <c:v>264</c:v>
                </c:pt>
                <c:pt idx="8">
                  <c:v>245</c:v>
                </c:pt>
                <c:pt idx="9">
                  <c:v>167</c:v>
                </c:pt>
                <c:pt idx="10">
                  <c:v>152</c:v>
                </c:pt>
                <c:pt idx="11">
                  <c:v>119</c:v>
                </c:pt>
                <c:pt idx="12">
                  <c:v>123</c:v>
                </c:pt>
                <c:pt idx="13">
                  <c:v>112</c:v>
                </c:pt>
                <c:pt idx="14">
                  <c:v>1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3533696"/>
        <c:axId val="50926336"/>
      </c:barChart>
      <c:lineChart>
        <c:grouping val="standard"/>
        <c:varyColors val="0"/>
        <c:ser>
          <c:idx val="5"/>
          <c:order val="5"/>
          <c:tx>
            <c:strRef>
              <c:f>'buried (2)'!$R$1</c:f>
              <c:strCache>
                <c:ptCount val="1"/>
                <c:pt idx="0">
                  <c:v>average accessibility</c:v>
                </c:pt>
              </c:strCache>
            </c:strRef>
          </c:tx>
          <c:spPr>
            <a:ln>
              <a:noFill/>
            </a:ln>
          </c:spPr>
          <c:marker>
            <c:symbol val="dash"/>
            <c:size val="7"/>
            <c:spPr>
              <a:solidFill>
                <a:sysClr val="windowText" lastClr="000000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uried (2)'!$T$2:$T$16</c:f>
                <c:numCache>
                  <c:formatCode>General</c:formatCode>
                  <c:ptCount val="15"/>
                  <c:pt idx="0">
                    <c:v>0.25</c:v>
                  </c:pt>
                  <c:pt idx="1">
                    <c:v>7.0000000000000007E-2</c:v>
                  </c:pt>
                  <c:pt idx="2">
                    <c:v>0.12</c:v>
                  </c:pt>
                  <c:pt idx="3">
                    <c:v>0.08</c:v>
                  </c:pt>
                  <c:pt idx="4">
                    <c:v>0.02</c:v>
                  </c:pt>
                  <c:pt idx="5">
                    <c:v>0.16</c:v>
                  </c:pt>
                  <c:pt idx="6">
                    <c:v>0.24</c:v>
                  </c:pt>
                  <c:pt idx="7">
                    <c:v>0.21</c:v>
                  </c:pt>
                  <c:pt idx="8">
                    <c:v>0.01</c:v>
                  </c:pt>
                  <c:pt idx="9">
                    <c:v>0.22</c:v>
                  </c:pt>
                  <c:pt idx="10">
                    <c:v>0.22</c:v>
                  </c:pt>
                  <c:pt idx="11">
                    <c:v>0.11</c:v>
                  </c:pt>
                  <c:pt idx="12">
                    <c:v>0</c:v>
                  </c:pt>
                  <c:pt idx="13">
                    <c:v>0.13</c:v>
                  </c:pt>
                  <c:pt idx="14">
                    <c:v>7.0000000000000007E-2</c:v>
                  </c:pt>
                </c:numCache>
              </c:numRef>
            </c:plus>
            <c:minus>
              <c:numRef>
                <c:f>'buried (2)'!$T$2:$T$16</c:f>
                <c:numCache>
                  <c:formatCode>General</c:formatCode>
                  <c:ptCount val="15"/>
                  <c:pt idx="0">
                    <c:v>0.25</c:v>
                  </c:pt>
                  <c:pt idx="1">
                    <c:v>7.0000000000000007E-2</c:v>
                  </c:pt>
                  <c:pt idx="2">
                    <c:v>0.12</c:v>
                  </c:pt>
                  <c:pt idx="3">
                    <c:v>0.08</c:v>
                  </c:pt>
                  <c:pt idx="4">
                    <c:v>0.02</c:v>
                  </c:pt>
                  <c:pt idx="5">
                    <c:v>0.16</c:v>
                  </c:pt>
                  <c:pt idx="6">
                    <c:v>0.24</c:v>
                  </c:pt>
                  <c:pt idx="7">
                    <c:v>0.21</c:v>
                  </c:pt>
                  <c:pt idx="8">
                    <c:v>0.01</c:v>
                  </c:pt>
                  <c:pt idx="9">
                    <c:v>0.22</c:v>
                  </c:pt>
                  <c:pt idx="10">
                    <c:v>0.22</c:v>
                  </c:pt>
                  <c:pt idx="11">
                    <c:v>0.11</c:v>
                  </c:pt>
                  <c:pt idx="12">
                    <c:v>0</c:v>
                  </c:pt>
                  <c:pt idx="13">
                    <c:v>0.13</c:v>
                  </c:pt>
                  <c:pt idx="14">
                    <c:v>7.0000000000000007E-2</c:v>
                  </c:pt>
                </c:numCache>
              </c:numRef>
            </c:minus>
          </c:errBars>
          <c:cat>
            <c:strRef>
              <c:f>'buried (2)'!$Z$2:$AA$16</c:f>
              <c:strCache>
                <c:ptCount val="15"/>
                <c:pt idx="0">
                  <c:v>Phosphotyrosine (0.09)</c:v>
                </c:pt>
                <c:pt idx="1">
                  <c:v>N6-(pyridoxal phosphate)lysine (0.96)</c:v>
                </c:pt>
                <c:pt idx="2">
                  <c:v>N6-carboxylysine (0.88)</c:v>
                </c:pt>
                <c:pt idx="3">
                  <c:v>4-aspartylphosphate (0.85)</c:v>
                </c:pt>
                <c:pt idx="4">
                  <c:v>3-methylthioaspartic acid (1)</c:v>
                </c:pt>
                <c:pt idx="5">
                  <c:v>Phosphohistidine (0.65)</c:v>
                </c:pt>
                <c:pt idx="6">
                  <c:v>Nitrated tyrosine (0.69)</c:v>
                </c:pt>
                <c:pt idx="7">
                  <c:v>S-nitrosocysteine (0.8)</c:v>
                </c:pt>
                <c:pt idx="8">
                  <c:v>N6-(retinylidene)lysine (1)</c:v>
                </c:pt>
                <c:pt idx="9">
                  <c:v>Methionine sulfoxide (0.99)</c:v>
                </c:pt>
                <c:pt idx="10">
                  <c:v>N6-(3,6-diaminohexanoyl)-5-hydroxylysine (1)</c:v>
                </c:pt>
                <c:pt idx="11">
                  <c:v>5-glutamyl glycerylphosphorylethanolamine (1)</c:v>
                </c:pt>
                <c:pt idx="12">
                  <c:v>Glycine radical (0.93)</c:v>
                </c:pt>
                <c:pt idx="13">
                  <c:v>Cysteine sulfenic acid (-SOH) (1)</c:v>
                </c:pt>
                <c:pt idx="14">
                  <c:v>N4-methylasparagine (0.96)</c:v>
                </c:pt>
              </c:strCache>
            </c:strRef>
          </c:cat>
          <c:val>
            <c:numRef>
              <c:f>'buried (2)'!$R$2:$R$16</c:f>
              <c:numCache>
                <c:formatCode>General</c:formatCode>
                <c:ptCount val="15"/>
                <c:pt idx="0">
                  <c:v>0.3</c:v>
                </c:pt>
                <c:pt idx="1">
                  <c:v>0.15</c:v>
                </c:pt>
                <c:pt idx="2">
                  <c:v>0.06</c:v>
                </c:pt>
                <c:pt idx="3">
                  <c:v>0.05</c:v>
                </c:pt>
                <c:pt idx="4">
                  <c:v>0.13</c:v>
                </c:pt>
                <c:pt idx="5">
                  <c:v>0.31</c:v>
                </c:pt>
                <c:pt idx="6">
                  <c:v>0.25</c:v>
                </c:pt>
                <c:pt idx="7">
                  <c:v>0.17</c:v>
                </c:pt>
                <c:pt idx="8">
                  <c:v>0.06</c:v>
                </c:pt>
                <c:pt idx="9">
                  <c:v>0.39</c:v>
                </c:pt>
                <c:pt idx="10">
                  <c:v>0.23</c:v>
                </c:pt>
                <c:pt idx="11">
                  <c:v>0.32</c:v>
                </c:pt>
                <c:pt idx="12">
                  <c:v>0</c:v>
                </c:pt>
                <c:pt idx="13">
                  <c:v>0.23</c:v>
                </c:pt>
                <c:pt idx="14">
                  <c:v>0.3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533696"/>
        <c:axId val="50926336"/>
      </c:lineChart>
      <c:lineChart>
        <c:grouping val="standard"/>
        <c:varyColors val="0"/>
        <c:ser>
          <c:idx val="3"/>
          <c:order val="3"/>
          <c:tx>
            <c:strRef>
              <c:f>'buried (2)'!$D$1</c:f>
              <c:strCache>
                <c:ptCount val="1"/>
                <c:pt idx="0">
                  <c:v>total nb. of PTMs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diamond"/>
            <c:size val="7"/>
            <c:spPr>
              <a:solidFill>
                <a:sysClr val="windowText" lastClr="000000"/>
              </a:solidFill>
              <a:ln>
                <a:noFill/>
              </a:ln>
            </c:spPr>
          </c:marker>
          <c:cat>
            <c:strRef>
              <c:f>'buried (2)'!$W$2:$W$16</c:f>
              <c:strCache>
                <c:ptCount val="15"/>
                <c:pt idx="0">
                  <c:v>Phosphotyrosine</c:v>
                </c:pt>
                <c:pt idx="1">
                  <c:v>N6-(pyridoxal phosphate)lysine</c:v>
                </c:pt>
                <c:pt idx="2">
                  <c:v>N6-carboxylysine</c:v>
                </c:pt>
                <c:pt idx="3">
                  <c:v>4-aspartylphosphate</c:v>
                </c:pt>
                <c:pt idx="4">
                  <c:v>3-methylthioaspartic acid</c:v>
                </c:pt>
                <c:pt idx="5">
                  <c:v>Phosphohistidine</c:v>
                </c:pt>
                <c:pt idx="6">
                  <c:v>Nitrated tyrosine</c:v>
                </c:pt>
                <c:pt idx="7">
                  <c:v>S-nitrosocysteine</c:v>
                </c:pt>
                <c:pt idx="8">
                  <c:v>N6-(retinylidene)lysine</c:v>
                </c:pt>
                <c:pt idx="9">
                  <c:v>Methionine sulfoxide</c:v>
                </c:pt>
                <c:pt idx="10">
                  <c:v>N6-(3,6-diaminohexanoyl)-5-hydroxylysine</c:v>
                </c:pt>
                <c:pt idx="11">
                  <c:v>5-glutamyl glycerylphosphorylethanolamine</c:v>
                </c:pt>
                <c:pt idx="12">
                  <c:v>Glycine radical</c:v>
                </c:pt>
                <c:pt idx="13">
                  <c:v>Cysteine sulfenic acid (-SOH)</c:v>
                </c:pt>
                <c:pt idx="14">
                  <c:v>N4-methylasparagine</c:v>
                </c:pt>
              </c:strCache>
            </c:strRef>
          </c:cat>
          <c:val>
            <c:numRef>
              <c:f>'buried (2)'!$D$2:$D$16</c:f>
              <c:numCache>
                <c:formatCode>General</c:formatCode>
                <c:ptCount val="15"/>
                <c:pt idx="0">
                  <c:v>8970</c:v>
                </c:pt>
                <c:pt idx="1">
                  <c:v>6443</c:v>
                </c:pt>
                <c:pt idx="2">
                  <c:v>1600</c:v>
                </c:pt>
                <c:pt idx="3">
                  <c:v>927</c:v>
                </c:pt>
                <c:pt idx="4">
                  <c:v>743</c:v>
                </c:pt>
                <c:pt idx="5">
                  <c:v>601</c:v>
                </c:pt>
                <c:pt idx="6">
                  <c:v>325</c:v>
                </c:pt>
                <c:pt idx="7">
                  <c:v>267</c:v>
                </c:pt>
                <c:pt idx="8">
                  <c:v>245</c:v>
                </c:pt>
                <c:pt idx="9">
                  <c:v>175</c:v>
                </c:pt>
                <c:pt idx="10">
                  <c:v>152</c:v>
                </c:pt>
                <c:pt idx="11">
                  <c:v>124</c:v>
                </c:pt>
                <c:pt idx="12">
                  <c:v>123</c:v>
                </c:pt>
                <c:pt idx="13">
                  <c:v>112</c:v>
                </c:pt>
                <c:pt idx="14">
                  <c:v>10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933760"/>
        <c:axId val="50927488"/>
      </c:lineChart>
      <c:catAx>
        <c:axId val="53533696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/>
          <a:lstStyle/>
          <a:p>
            <a:pPr>
              <a:defRPr sz="900"/>
            </a:pPr>
            <a:endParaRPr lang="de-DE"/>
          </a:p>
        </c:txPr>
        <c:crossAx val="50926336"/>
        <c:crosses val="autoZero"/>
        <c:auto val="1"/>
        <c:lblAlgn val="ctr"/>
        <c:lblOffset val="100"/>
        <c:noMultiLvlLbl val="0"/>
      </c:catAx>
      <c:valAx>
        <c:axId val="50926336"/>
        <c:scaling>
          <c:orientation val="minMax"/>
        </c:scaling>
        <c:delete val="0"/>
        <c:axPos val="l"/>
        <c:majorGridlines/>
        <c:numFmt formatCode="0%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de-DE"/>
          </a:p>
        </c:txPr>
        <c:crossAx val="53533696"/>
        <c:crosses val="autoZero"/>
        <c:crossBetween val="between"/>
      </c:valAx>
      <c:valAx>
        <c:axId val="50927488"/>
        <c:scaling>
          <c:orientation val="minMax"/>
          <c:max val="12000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Total Number</a:t>
                </a:r>
                <a:r>
                  <a:rPr lang="en-US" sz="1200" baseline="0"/>
                  <a:t> of PTMs</a:t>
                </a:r>
                <a:endParaRPr lang="en-US" sz="12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de-DE"/>
          </a:p>
        </c:txPr>
        <c:crossAx val="50933760"/>
        <c:crosses val="max"/>
        <c:crossBetween val="between"/>
        <c:minorUnit val="2000"/>
      </c:valAx>
      <c:catAx>
        <c:axId val="50933760"/>
        <c:scaling>
          <c:orientation val="minMax"/>
        </c:scaling>
        <c:delete val="1"/>
        <c:axPos val="b"/>
        <c:majorTickMark val="out"/>
        <c:minorTickMark val="none"/>
        <c:tickLblPos val="none"/>
        <c:crossAx val="50927488"/>
        <c:crosses val="autoZero"/>
        <c:auto val="1"/>
        <c:lblAlgn val="ctr"/>
        <c:lblOffset val="100"/>
        <c:noMultiLvlLbl val="0"/>
      </c:catAx>
    </c:plotArea>
    <c:legend>
      <c:legendPos val="t"/>
      <c:layout/>
      <c:overlay val="0"/>
      <c:txPr>
        <a:bodyPr/>
        <a:lstStyle/>
        <a:p>
          <a:pPr>
            <a:defRPr sz="1000"/>
          </a:pPr>
          <a:endParaRPr lang="de-DE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LIPID</a:t>
            </a:r>
          </a:p>
        </c:rich>
      </c:tx>
      <c:layout/>
      <c:overlay val="0"/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lipid-disprot-iupred (4)'!$B$1</c:f>
              <c:strCache>
                <c:ptCount val="1"/>
                <c:pt idx="0">
                  <c:v>% DisProt</c:v>
                </c:pt>
              </c:strCache>
            </c:strRef>
          </c:tx>
          <c:spPr>
            <a:solidFill>
              <a:srgbClr val="FF0000"/>
            </a:solidFill>
            <a:ln w="12700">
              <a:solidFill>
                <a:srgbClr val="FF0000"/>
              </a:solidFill>
              <a:prstDash val="solid"/>
            </a:ln>
          </c:spPr>
          <c:invertIfNegative val="0"/>
          <c:cat>
            <c:strRef>
              <c:f>'lipid-disprot-iupred (4)'!$BI$2:$BI$39</c:f>
              <c:strCache>
                <c:ptCount val="38"/>
                <c:pt idx="0">
                  <c:v>N-palmitoyl cysteine (-0.97)</c:v>
                </c:pt>
                <c:pt idx="1">
                  <c:v>S-diacylglycerol cysteine (-0.97)</c:v>
                </c:pt>
                <c:pt idx="2">
                  <c:v>N-myristoyl glycine (-0.17)</c:v>
                </c:pt>
                <c:pt idx="3">
                  <c:v>N-palmitoyl glycine (-1)</c:v>
                </c:pt>
                <c:pt idx="4">
                  <c:v>S-archaeol cysteine (-1)</c:v>
                </c:pt>
                <c:pt idx="5">
                  <c:v>N-(12-oxomyristoyl)cysteine (-1)</c:v>
                </c:pt>
                <c:pt idx="6">
                  <c:v>N-[(12R)-12-hydroxymyristoyl]cysteine (-1)</c:v>
                </c:pt>
                <c:pt idx="7">
                  <c:v>S-palmitoyl cysteine (-0.4)</c:v>
                </c:pt>
                <c:pt idx="8">
                  <c:v>S-geranylgeranyl cysteine (-0.78)</c:v>
                </c:pt>
                <c:pt idx="9">
                  <c:v>S-farnesyl cysteine (-0.85)</c:v>
                </c:pt>
                <c:pt idx="10">
                  <c:v>O-palmitoyl serine (0.9)</c:v>
                </c:pt>
                <c:pt idx="11">
                  <c:v>N6-myristoyl lysine (-0.93)</c:v>
                </c:pt>
                <c:pt idx="12">
                  <c:v>N6-palmitoyl lysine (-0.54)</c:v>
                </c:pt>
                <c:pt idx="13">
                  <c:v>O-octanoyl serine (-1)</c:v>
                </c:pt>
                <c:pt idx="14">
                  <c:v>S-stearoyl cysteine (0.45)</c:v>
                </c:pt>
                <c:pt idx="15">
                  <c:v>S-(15-deoxy-Delta12,14-prostaglandin J2-9-yl)cysteine (0.4)</c:v>
                </c:pt>
                <c:pt idx="16">
                  <c:v>Omega-hydroxyceramide glutamate ester (-1)</c:v>
                </c:pt>
                <c:pt idx="17">
                  <c:v>O-decanoyl serine (-1)</c:v>
                </c:pt>
                <c:pt idx="18">
                  <c:v>O-palmitoyl threonine (-1)</c:v>
                </c:pt>
                <c:pt idx="19">
                  <c:v>3'-geranyl-2',N2-cyclotryptophan (-1)</c:v>
                </c:pt>
                <c:pt idx="20">
                  <c:v>Cis-14-hydroxy-10,13-dioxo-7-heptadecenoic acid aspartate ester (1)</c:v>
                </c:pt>
                <c:pt idx="21">
                  <c:v>S-12-hydroxyfarnesyl cysteine (-1)</c:v>
                </c:pt>
                <c:pt idx="22">
                  <c:v>O-decanoyl threonine (-1)</c:v>
                </c:pt>
                <c:pt idx="23">
                  <c:v>O-octanoyl threonine (-1)</c:v>
                </c:pt>
                <c:pt idx="24">
                  <c:v>GPI-anchor amidated serine (-0.61)</c:v>
                </c:pt>
                <c:pt idx="25">
                  <c:v>GPI-anchor amidated asparagine (-0.81)</c:v>
                </c:pt>
                <c:pt idx="26">
                  <c:v>GPI-anchor amidated glycine (-0.79)</c:v>
                </c:pt>
                <c:pt idx="27">
                  <c:v>GPI-anchor amidated alanine (-0.28)</c:v>
                </c:pt>
                <c:pt idx="28">
                  <c:v>Phosphatidylethanolamine amidated glycine (1)</c:v>
                </c:pt>
                <c:pt idx="29">
                  <c:v>GPI-anchor amidated aspartate (-0.44)</c:v>
                </c:pt>
                <c:pt idx="30">
                  <c:v>Cholesterol glycine ester (-1)</c:v>
                </c:pt>
                <c:pt idx="31">
                  <c:v>GPI-like-anchor amidated serine (-1)</c:v>
                </c:pt>
                <c:pt idx="32">
                  <c:v>GPI-anchor amidated cysteine (-0.6)</c:v>
                </c:pt>
                <c:pt idx="33">
                  <c:v>GPI-like-anchor amidated asparagine (-1)</c:v>
                </c:pt>
                <c:pt idx="34">
                  <c:v>GPI-like-anchor amidated alanine (-1)</c:v>
                </c:pt>
                <c:pt idx="35">
                  <c:v>GPI-like-anchor amidated glycine (-1)</c:v>
                </c:pt>
                <c:pt idx="36">
                  <c:v>GPI-anchor amidated threonine (-1)</c:v>
                </c:pt>
                <c:pt idx="37">
                  <c:v>GPI-like-anchor amidated aspartate (-1)</c:v>
                </c:pt>
              </c:strCache>
            </c:strRef>
          </c:cat>
          <c:val>
            <c:numRef>
              <c:f>'lipid-disprot-iupred (4)'!$B$2:$B$39</c:f>
              <c:numCache>
                <c:formatCode>General</c:formatCode>
                <c:ptCount val="38"/>
                <c:pt idx="0">
                  <c:v>2</c:v>
                </c:pt>
                <c:pt idx="1">
                  <c:v>2</c:v>
                </c:pt>
                <c:pt idx="2">
                  <c:v>7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0</c:v>
                </c:pt>
                <c:pt idx="8">
                  <c:v>0</c:v>
                </c:pt>
                <c:pt idx="9">
                  <c:v>4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</c:numCache>
            </c:numRef>
          </c:val>
        </c:ser>
        <c:ser>
          <c:idx val="1"/>
          <c:order val="1"/>
          <c:tx>
            <c:strRef>
              <c:f>'lipid-disprot-iupred (4)'!$C$1</c:f>
              <c:strCache>
                <c:ptCount val="1"/>
                <c:pt idx="0">
                  <c:v>% IUPred</c:v>
                </c:pt>
              </c:strCache>
            </c:strRef>
          </c:tx>
          <c:spPr>
            <a:solidFill>
              <a:srgbClr val="0070C0"/>
            </a:solidFill>
            <a:ln w="12700">
              <a:solidFill>
                <a:schemeClr val="accent1"/>
              </a:solidFill>
            </a:ln>
          </c:spPr>
          <c:invertIfNegative val="0"/>
          <c:cat>
            <c:strRef>
              <c:f>'lipid-disprot-iupred (4)'!$BI$2:$BI$39</c:f>
              <c:strCache>
                <c:ptCount val="38"/>
                <c:pt idx="0">
                  <c:v>N-palmitoyl cysteine (-0.97)</c:v>
                </c:pt>
                <c:pt idx="1">
                  <c:v>S-diacylglycerol cysteine (-0.97)</c:v>
                </c:pt>
                <c:pt idx="2">
                  <c:v>N-myristoyl glycine (-0.17)</c:v>
                </c:pt>
                <c:pt idx="3">
                  <c:v>N-palmitoyl glycine (-1)</c:v>
                </c:pt>
                <c:pt idx="4">
                  <c:v>S-archaeol cysteine (-1)</c:v>
                </c:pt>
                <c:pt idx="5">
                  <c:v>N-(12-oxomyristoyl)cysteine (-1)</c:v>
                </c:pt>
                <c:pt idx="6">
                  <c:v>N-[(12R)-12-hydroxymyristoyl]cysteine (-1)</c:v>
                </c:pt>
                <c:pt idx="7">
                  <c:v>S-palmitoyl cysteine (-0.4)</c:v>
                </c:pt>
                <c:pt idx="8">
                  <c:v>S-geranylgeranyl cysteine (-0.78)</c:v>
                </c:pt>
                <c:pt idx="9">
                  <c:v>S-farnesyl cysteine (-0.85)</c:v>
                </c:pt>
                <c:pt idx="10">
                  <c:v>O-palmitoyl serine (0.9)</c:v>
                </c:pt>
                <c:pt idx="11">
                  <c:v>N6-myristoyl lysine (-0.93)</c:v>
                </c:pt>
                <c:pt idx="12">
                  <c:v>N6-palmitoyl lysine (-0.54)</c:v>
                </c:pt>
                <c:pt idx="13">
                  <c:v>O-octanoyl serine (-1)</c:v>
                </c:pt>
                <c:pt idx="14">
                  <c:v>S-stearoyl cysteine (0.45)</c:v>
                </c:pt>
                <c:pt idx="15">
                  <c:v>S-(15-deoxy-Delta12,14-prostaglandin J2-9-yl)cysteine (0.4)</c:v>
                </c:pt>
                <c:pt idx="16">
                  <c:v>Omega-hydroxyceramide glutamate ester (-1)</c:v>
                </c:pt>
                <c:pt idx="17">
                  <c:v>O-decanoyl serine (-1)</c:v>
                </c:pt>
                <c:pt idx="18">
                  <c:v>O-palmitoyl threonine (-1)</c:v>
                </c:pt>
                <c:pt idx="19">
                  <c:v>3'-geranyl-2',N2-cyclotryptophan (-1)</c:v>
                </c:pt>
                <c:pt idx="20">
                  <c:v>Cis-14-hydroxy-10,13-dioxo-7-heptadecenoic acid aspartate ester (1)</c:v>
                </c:pt>
                <c:pt idx="21">
                  <c:v>S-12-hydroxyfarnesyl cysteine (-1)</c:v>
                </c:pt>
                <c:pt idx="22">
                  <c:v>O-decanoyl threonine (-1)</c:v>
                </c:pt>
                <c:pt idx="23">
                  <c:v>O-octanoyl threonine (-1)</c:v>
                </c:pt>
                <c:pt idx="24">
                  <c:v>GPI-anchor amidated serine (-0.61)</c:v>
                </c:pt>
                <c:pt idx="25">
                  <c:v>GPI-anchor amidated asparagine (-0.81)</c:v>
                </c:pt>
                <c:pt idx="26">
                  <c:v>GPI-anchor amidated glycine (-0.79)</c:v>
                </c:pt>
                <c:pt idx="27">
                  <c:v>GPI-anchor amidated alanine (-0.28)</c:v>
                </c:pt>
                <c:pt idx="28">
                  <c:v>Phosphatidylethanolamine amidated glycine (1)</c:v>
                </c:pt>
                <c:pt idx="29">
                  <c:v>GPI-anchor amidated aspartate (-0.44)</c:v>
                </c:pt>
                <c:pt idx="30">
                  <c:v>Cholesterol glycine ester (-1)</c:v>
                </c:pt>
                <c:pt idx="31">
                  <c:v>GPI-like-anchor amidated serine (-1)</c:v>
                </c:pt>
                <c:pt idx="32">
                  <c:v>GPI-anchor amidated cysteine (-0.6)</c:v>
                </c:pt>
                <c:pt idx="33">
                  <c:v>GPI-like-anchor amidated asparagine (-1)</c:v>
                </c:pt>
                <c:pt idx="34">
                  <c:v>GPI-like-anchor amidated alanine (-1)</c:v>
                </c:pt>
                <c:pt idx="35">
                  <c:v>GPI-like-anchor amidated glycine (-1)</c:v>
                </c:pt>
                <c:pt idx="36">
                  <c:v>GPI-anchor amidated threonine (-1)</c:v>
                </c:pt>
                <c:pt idx="37">
                  <c:v>GPI-like-anchor amidated aspartate (-1)</c:v>
                </c:pt>
              </c:strCache>
            </c:strRef>
          </c:cat>
          <c:val>
            <c:numRef>
              <c:f>'lipid-disprot-iupred (4)'!$C$2:$C$39</c:f>
              <c:numCache>
                <c:formatCode>General</c:formatCode>
                <c:ptCount val="38"/>
                <c:pt idx="0">
                  <c:v>29</c:v>
                </c:pt>
                <c:pt idx="1">
                  <c:v>29</c:v>
                </c:pt>
                <c:pt idx="2">
                  <c:v>429</c:v>
                </c:pt>
                <c:pt idx="3">
                  <c:v>16</c:v>
                </c:pt>
                <c:pt idx="4">
                  <c:v>2</c:v>
                </c:pt>
                <c:pt idx="5">
                  <c:v>0</c:v>
                </c:pt>
                <c:pt idx="6">
                  <c:v>0</c:v>
                </c:pt>
                <c:pt idx="7">
                  <c:v>109</c:v>
                </c:pt>
                <c:pt idx="8">
                  <c:v>197</c:v>
                </c:pt>
                <c:pt idx="9">
                  <c:v>90</c:v>
                </c:pt>
                <c:pt idx="10">
                  <c:v>0</c:v>
                </c:pt>
                <c:pt idx="11">
                  <c:v>6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5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2</c:v>
                </c:pt>
                <c:pt idx="22">
                  <c:v>0</c:v>
                </c:pt>
                <c:pt idx="23">
                  <c:v>0</c:v>
                </c:pt>
                <c:pt idx="24">
                  <c:v>50</c:v>
                </c:pt>
                <c:pt idx="25">
                  <c:v>31</c:v>
                </c:pt>
                <c:pt idx="26">
                  <c:v>28</c:v>
                </c:pt>
                <c:pt idx="27">
                  <c:v>7</c:v>
                </c:pt>
                <c:pt idx="28">
                  <c:v>0</c:v>
                </c:pt>
                <c:pt idx="29">
                  <c:v>7</c:v>
                </c:pt>
                <c:pt idx="30">
                  <c:v>0</c:v>
                </c:pt>
                <c:pt idx="31">
                  <c:v>6</c:v>
                </c:pt>
                <c:pt idx="32">
                  <c:v>3</c:v>
                </c:pt>
                <c:pt idx="33">
                  <c:v>4</c:v>
                </c:pt>
                <c:pt idx="34">
                  <c:v>2</c:v>
                </c:pt>
                <c:pt idx="35">
                  <c:v>3</c:v>
                </c:pt>
                <c:pt idx="36">
                  <c:v>0</c:v>
                </c:pt>
                <c:pt idx="37">
                  <c:v>0</c:v>
                </c:pt>
              </c:numCache>
            </c:numRef>
          </c:val>
        </c:ser>
        <c:ser>
          <c:idx val="4"/>
          <c:order val="2"/>
          <c:tx>
            <c:strRef>
              <c:f>'lipid-disprot-iupred (4)'!$D$1</c:f>
              <c:strCache>
                <c:ptCount val="1"/>
                <c:pt idx="0">
                  <c:v>% Both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rgbClr val="00B050"/>
              </a:solidFill>
            </a:ln>
          </c:spPr>
          <c:invertIfNegative val="0"/>
          <c:cat>
            <c:strRef>
              <c:f>'lipid-disprot-iupred (4)'!$BI$2:$BI$39</c:f>
              <c:strCache>
                <c:ptCount val="38"/>
                <c:pt idx="0">
                  <c:v>N-palmitoyl cysteine (-0.97)</c:v>
                </c:pt>
                <c:pt idx="1">
                  <c:v>S-diacylglycerol cysteine (-0.97)</c:v>
                </c:pt>
                <c:pt idx="2">
                  <c:v>N-myristoyl glycine (-0.17)</c:v>
                </c:pt>
                <c:pt idx="3">
                  <c:v>N-palmitoyl glycine (-1)</c:v>
                </c:pt>
                <c:pt idx="4">
                  <c:v>S-archaeol cysteine (-1)</c:v>
                </c:pt>
                <c:pt idx="5">
                  <c:v>N-(12-oxomyristoyl)cysteine (-1)</c:v>
                </c:pt>
                <c:pt idx="6">
                  <c:v>N-[(12R)-12-hydroxymyristoyl]cysteine (-1)</c:v>
                </c:pt>
                <c:pt idx="7">
                  <c:v>S-palmitoyl cysteine (-0.4)</c:v>
                </c:pt>
                <c:pt idx="8">
                  <c:v>S-geranylgeranyl cysteine (-0.78)</c:v>
                </c:pt>
                <c:pt idx="9">
                  <c:v>S-farnesyl cysteine (-0.85)</c:v>
                </c:pt>
                <c:pt idx="10">
                  <c:v>O-palmitoyl serine (0.9)</c:v>
                </c:pt>
                <c:pt idx="11">
                  <c:v>N6-myristoyl lysine (-0.93)</c:v>
                </c:pt>
                <c:pt idx="12">
                  <c:v>N6-palmitoyl lysine (-0.54)</c:v>
                </c:pt>
                <c:pt idx="13">
                  <c:v>O-octanoyl serine (-1)</c:v>
                </c:pt>
                <c:pt idx="14">
                  <c:v>S-stearoyl cysteine (0.45)</c:v>
                </c:pt>
                <c:pt idx="15">
                  <c:v>S-(15-deoxy-Delta12,14-prostaglandin J2-9-yl)cysteine (0.4)</c:v>
                </c:pt>
                <c:pt idx="16">
                  <c:v>Omega-hydroxyceramide glutamate ester (-1)</c:v>
                </c:pt>
                <c:pt idx="17">
                  <c:v>O-decanoyl serine (-1)</c:v>
                </c:pt>
                <c:pt idx="18">
                  <c:v>O-palmitoyl threonine (-1)</c:v>
                </c:pt>
                <c:pt idx="19">
                  <c:v>3'-geranyl-2',N2-cyclotryptophan (-1)</c:v>
                </c:pt>
                <c:pt idx="20">
                  <c:v>Cis-14-hydroxy-10,13-dioxo-7-heptadecenoic acid aspartate ester (1)</c:v>
                </c:pt>
                <c:pt idx="21">
                  <c:v>S-12-hydroxyfarnesyl cysteine (-1)</c:v>
                </c:pt>
                <c:pt idx="22">
                  <c:v>O-decanoyl threonine (-1)</c:v>
                </c:pt>
                <c:pt idx="23">
                  <c:v>O-octanoyl threonine (-1)</c:v>
                </c:pt>
                <c:pt idx="24">
                  <c:v>GPI-anchor amidated serine (-0.61)</c:v>
                </c:pt>
                <c:pt idx="25">
                  <c:v>GPI-anchor amidated asparagine (-0.81)</c:v>
                </c:pt>
                <c:pt idx="26">
                  <c:v>GPI-anchor amidated glycine (-0.79)</c:v>
                </c:pt>
                <c:pt idx="27">
                  <c:v>GPI-anchor amidated alanine (-0.28)</c:v>
                </c:pt>
                <c:pt idx="28">
                  <c:v>Phosphatidylethanolamine amidated glycine (1)</c:v>
                </c:pt>
                <c:pt idx="29">
                  <c:v>GPI-anchor amidated aspartate (-0.44)</c:v>
                </c:pt>
                <c:pt idx="30">
                  <c:v>Cholesterol glycine ester (-1)</c:v>
                </c:pt>
                <c:pt idx="31">
                  <c:v>GPI-like-anchor amidated serine (-1)</c:v>
                </c:pt>
                <c:pt idx="32">
                  <c:v>GPI-anchor amidated cysteine (-0.6)</c:v>
                </c:pt>
                <c:pt idx="33">
                  <c:v>GPI-like-anchor amidated asparagine (-1)</c:v>
                </c:pt>
                <c:pt idx="34">
                  <c:v>GPI-like-anchor amidated alanine (-1)</c:v>
                </c:pt>
                <c:pt idx="35">
                  <c:v>GPI-like-anchor amidated glycine (-1)</c:v>
                </c:pt>
                <c:pt idx="36">
                  <c:v>GPI-anchor amidated threonine (-1)</c:v>
                </c:pt>
                <c:pt idx="37">
                  <c:v>GPI-like-anchor amidated aspartate (-1)</c:v>
                </c:pt>
              </c:strCache>
            </c:strRef>
          </c:cat>
          <c:val>
            <c:numRef>
              <c:f>'lipid-disprot-iupred (4)'!$D$2:$D$39</c:f>
              <c:numCache>
                <c:formatCode>General</c:formatCode>
                <c:ptCount val="38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</c:numCache>
            </c:numRef>
          </c:val>
        </c:ser>
        <c:ser>
          <c:idx val="2"/>
          <c:order val="3"/>
          <c:tx>
            <c:strRef>
              <c:f>'lipid-disprot-iupred (4)'!$F$1</c:f>
              <c:strCache>
                <c:ptCount val="1"/>
                <c:pt idx="0">
                  <c:v>% Other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12700">
              <a:solidFill>
                <a:schemeClr val="bg1">
                  <a:lumMod val="85000"/>
                </a:schemeClr>
              </a:solidFill>
            </a:ln>
          </c:spPr>
          <c:invertIfNegative val="0"/>
          <c:cat>
            <c:strRef>
              <c:f>'lipid-disprot-iupred (4)'!$BI$2:$BI$39</c:f>
              <c:strCache>
                <c:ptCount val="38"/>
                <c:pt idx="0">
                  <c:v>N-palmitoyl cysteine (-0.97)</c:v>
                </c:pt>
                <c:pt idx="1">
                  <c:v>S-diacylglycerol cysteine (-0.97)</c:v>
                </c:pt>
                <c:pt idx="2">
                  <c:v>N-myristoyl glycine (-0.17)</c:v>
                </c:pt>
                <c:pt idx="3">
                  <c:v>N-palmitoyl glycine (-1)</c:v>
                </c:pt>
                <c:pt idx="4">
                  <c:v>S-archaeol cysteine (-1)</c:v>
                </c:pt>
                <c:pt idx="5">
                  <c:v>N-(12-oxomyristoyl)cysteine (-1)</c:v>
                </c:pt>
                <c:pt idx="6">
                  <c:v>N-[(12R)-12-hydroxymyristoyl]cysteine (-1)</c:v>
                </c:pt>
                <c:pt idx="7">
                  <c:v>S-palmitoyl cysteine (-0.4)</c:v>
                </c:pt>
                <c:pt idx="8">
                  <c:v>S-geranylgeranyl cysteine (-0.78)</c:v>
                </c:pt>
                <c:pt idx="9">
                  <c:v>S-farnesyl cysteine (-0.85)</c:v>
                </c:pt>
                <c:pt idx="10">
                  <c:v>O-palmitoyl serine (0.9)</c:v>
                </c:pt>
                <c:pt idx="11">
                  <c:v>N6-myristoyl lysine (-0.93)</c:v>
                </c:pt>
                <c:pt idx="12">
                  <c:v>N6-palmitoyl lysine (-0.54)</c:v>
                </c:pt>
                <c:pt idx="13">
                  <c:v>O-octanoyl serine (-1)</c:v>
                </c:pt>
                <c:pt idx="14">
                  <c:v>S-stearoyl cysteine (0.45)</c:v>
                </c:pt>
                <c:pt idx="15">
                  <c:v>S-(15-deoxy-Delta12,14-prostaglandin J2-9-yl)cysteine (0.4)</c:v>
                </c:pt>
                <c:pt idx="16">
                  <c:v>Omega-hydroxyceramide glutamate ester (-1)</c:v>
                </c:pt>
                <c:pt idx="17">
                  <c:v>O-decanoyl serine (-1)</c:v>
                </c:pt>
                <c:pt idx="18">
                  <c:v>O-palmitoyl threonine (-1)</c:v>
                </c:pt>
                <c:pt idx="19">
                  <c:v>3'-geranyl-2',N2-cyclotryptophan (-1)</c:v>
                </c:pt>
                <c:pt idx="20">
                  <c:v>Cis-14-hydroxy-10,13-dioxo-7-heptadecenoic acid aspartate ester (1)</c:v>
                </c:pt>
                <c:pt idx="21">
                  <c:v>S-12-hydroxyfarnesyl cysteine (-1)</c:v>
                </c:pt>
                <c:pt idx="22">
                  <c:v>O-decanoyl threonine (-1)</c:v>
                </c:pt>
                <c:pt idx="23">
                  <c:v>O-octanoyl threonine (-1)</c:v>
                </c:pt>
                <c:pt idx="24">
                  <c:v>GPI-anchor amidated serine (-0.61)</c:v>
                </c:pt>
                <c:pt idx="25">
                  <c:v>GPI-anchor amidated asparagine (-0.81)</c:v>
                </c:pt>
                <c:pt idx="26">
                  <c:v>GPI-anchor amidated glycine (-0.79)</c:v>
                </c:pt>
                <c:pt idx="27">
                  <c:v>GPI-anchor amidated alanine (-0.28)</c:v>
                </c:pt>
                <c:pt idx="28">
                  <c:v>Phosphatidylethanolamine amidated glycine (1)</c:v>
                </c:pt>
                <c:pt idx="29">
                  <c:v>GPI-anchor amidated aspartate (-0.44)</c:v>
                </c:pt>
                <c:pt idx="30">
                  <c:v>Cholesterol glycine ester (-1)</c:v>
                </c:pt>
                <c:pt idx="31">
                  <c:v>GPI-like-anchor amidated serine (-1)</c:v>
                </c:pt>
                <c:pt idx="32">
                  <c:v>GPI-anchor amidated cysteine (-0.6)</c:v>
                </c:pt>
                <c:pt idx="33">
                  <c:v>GPI-like-anchor amidated asparagine (-1)</c:v>
                </c:pt>
                <c:pt idx="34">
                  <c:v>GPI-like-anchor amidated alanine (-1)</c:v>
                </c:pt>
                <c:pt idx="35">
                  <c:v>GPI-like-anchor amidated glycine (-1)</c:v>
                </c:pt>
                <c:pt idx="36">
                  <c:v>GPI-anchor amidated threonine (-1)</c:v>
                </c:pt>
                <c:pt idx="37">
                  <c:v>GPI-like-anchor amidated aspartate (-1)</c:v>
                </c:pt>
              </c:strCache>
            </c:strRef>
          </c:cat>
          <c:val>
            <c:numRef>
              <c:f>'lipid-disprot-iupred (4)'!$F$2:$F$39</c:f>
              <c:numCache>
                <c:formatCode>General</c:formatCode>
                <c:ptCount val="38"/>
                <c:pt idx="0">
                  <c:v>2027</c:v>
                </c:pt>
                <c:pt idx="1">
                  <c:v>1999</c:v>
                </c:pt>
                <c:pt idx="2">
                  <c:v>1005</c:v>
                </c:pt>
                <c:pt idx="3">
                  <c:v>2</c:v>
                </c:pt>
                <c:pt idx="4">
                  <c:v>10</c:v>
                </c:pt>
                <c:pt idx="5">
                  <c:v>1</c:v>
                </c:pt>
                <c:pt idx="6">
                  <c:v>1</c:v>
                </c:pt>
                <c:pt idx="7">
                  <c:v>3500</c:v>
                </c:pt>
                <c:pt idx="8">
                  <c:v>899</c:v>
                </c:pt>
                <c:pt idx="9">
                  <c:v>275</c:v>
                </c:pt>
                <c:pt idx="10">
                  <c:v>164</c:v>
                </c:pt>
                <c:pt idx="11">
                  <c:v>50</c:v>
                </c:pt>
                <c:pt idx="12">
                  <c:v>13</c:v>
                </c:pt>
                <c:pt idx="13">
                  <c:v>12</c:v>
                </c:pt>
                <c:pt idx="14">
                  <c:v>11</c:v>
                </c:pt>
                <c:pt idx="15">
                  <c:v>9</c:v>
                </c:pt>
                <c:pt idx="16">
                  <c:v>4</c:v>
                </c:pt>
                <c:pt idx="17">
                  <c:v>6</c:v>
                </c:pt>
                <c:pt idx="18">
                  <c:v>5</c:v>
                </c:pt>
                <c:pt idx="19">
                  <c:v>2</c:v>
                </c:pt>
                <c:pt idx="20">
                  <c:v>2</c:v>
                </c:pt>
                <c:pt idx="21">
                  <c:v>0</c:v>
                </c:pt>
                <c:pt idx="22">
                  <c:v>1</c:v>
                </c:pt>
                <c:pt idx="23">
                  <c:v>1</c:v>
                </c:pt>
                <c:pt idx="24">
                  <c:v>328</c:v>
                </c:pt>
                <c:pt idx="25">
                  <c:v>136</c:v>
                </c:pt>
                <c:pt idx="26">
                  <c:v>136</c:v>
                </c:pt>
                <c:pt idx="27">
                  <c:v>82</c:v>
                </c:pt>
                <c:pt idx="28">
                  <c:v>81</c:v>
                </c:pt>
                <c:pt idx="29">
                  <c:v>43</c:v>
                </c:pt>
                <c:pt idx="30">
                  <c:v>30</c:v>
                </c:pt>
                <c:pt idx="31">
                  <c:v>10</c:v>
                </c:pt>
                <c:pt idx="32">
                  <c:v>12</c:v>
                </c:pt>
                <c:pt idx="33">
                  <c:v>11</c:v>
                </c:pt>
                <c:pt idx="34">
                  <c:v>5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3610752"/>
        <c:axId val="53625216"/>
      </c:barChart>
      <c:lineChart>
        <c:grouping val="standard"/>
        <c:varyColors val="0"/>
        <c:ser>
          <c:idx val="5"/>
          <c:order val="5"/>
          <c:tx>
            <c:strRef>
              <c:f>'lipid-disprot-iupred (4)'!$AN$1</c:f>
              <c:strCache>
                <c:ptCount val="1"/>
                <c:pt idx="0">
                  <c:v>average accessibility</c:v>
                </c:pt>
              </c:strCache>
            </c:strRef>
          </c:tx>
          <c:spPr>
            <a:ln>
              <a:noFill/>
            </a:ln>
          </c:spPr>
          <c:marker>
            <c:symbol val="dash"/>
            <c:size val="7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lipid-disprot-iupred (4)'!$AP$2:$AP$39</c:f>
                <c:numCache>
                  <c:formatCode>General</c:formatCode>
                  <c:ptCount val="38"/>
                  <c:pt idx="0">
                    <c:v>0.28999999999999998</c:v>
                  </c:pt>
                  <c:pt idx="1">
                    <c:v>0.28999999999999998</c:v>
                  </c:pt>
                  <c:pt idx="2">
                    <c:v>0.41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.38</c:v>
                  </c:pt>
                  <c:pt idx="8">
                    <c:v>0.45</c:v>
                  </c:pt>
                  <c:pt idx="9">
                    <c:v>0.28999999999999998</c:v>
                  </c:pt>
                  <c:pt idx="10">
                    <c:v>0</c:v>
                  </c:pt>
                  <c:pt idx="11">
                    <c:v>0</c:v>
                  </c:pt>
                  <c:pt idx="12">
                    <c:v>0.09</c:v>
                  </c:pt>
                  <c:pt idx="13">
                    <c:v>0</c:v>
                  </c:pt>
                  <c:pt idx="14">
                    <c:v>0.2</c:v>
                  </c:pt>
                  <c:pt idx="15">
                    <c:v>0.42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.05</c:v>
                  </c:pt>
                  <c:pt idx="21">
                    <c:v>0</c:v>
                  </c:pt>
                  <c:pt idx="22">
                    <c:v>0</c:v>
                  </c:pt>
                  <c:pt idx="23">
                    <c:v>0</c:v>
                  </c:pt>
                  <c:pt idx="24">
                    <c:v>0.3</c:v>
                  </c:pt>
                  <c:pt idx="25">
                    <c:v>0.19</c:v>
                  </c:pt>
                  <c:pt idx="26">
                    <c:v>0.25</c:v>
                  </c:pt>
                  <c:pt idx="27">
                    <c:v>0.09</c:v>
                  </c:pt>
                  <c:pt idx="28">
                    <c:v>0.27</c:v>
                  </c:pt>
                  <c:pt idx="29">
                    <c:v>0.21</c:v>
                  </c:pt>
                  <c:pt idx="30">
                    <c:v>0</c:v>
                  </c:pt>
                  <c:pt idx="31">
                    <c:v>0</c:v>
                  </c:pt>
                  <c:pt idx="32">
                    <c:v>0.09</c:v>
                  </c:pt>
                  <c:pt idx="33">
                    <c:v>0</c:v>
                  </c:pt>
                  <c:pt idx="34">
                    <c:v>0</c:v>
                  </c:pt>
                  <c:pt idx="35">
                    <c:v>0</c:v>
                  </c:pt>
                  <c:pt idx="36">
                    <c:v>0</c:v>
                  </c:pt>
                  <c:pt idx="37">
                    <c:v>0</c:v>
                  </c:pt>
                </c:numCache>
              </c:numRef>
            </c:plus>
            <c:minus>
              <c:numRef>
                <c:f>'lipid-disprot-iupred (4)'!$AP$2:$AP$39</c:f>
                <c:numCache>
                  <c:formatCode>General</c:formatCode>
                  <c:ptCount val="38"/>
                  <c:pt idx="0">
                    <c:v>0.28999999999999998</c:v>
                  </c:pt>
                  <c:pt idx="1">
                    <c:v>0.28999999999999998</c:v>
                  </c:pt>
                  <c:pt idx="2">
                    <c:v>0.41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.38</c:v>
                  </c:pt>
                  <c:pt idx="8">
                    <c:v>0.45</c:v>
                  </c:pt>
                  <c:pt idx="9">
                    <c:v>0.28999999999999998</c:v>
                  </c:pt>
                  <c:pt idx="10">
                    <c:v>0</c:v>
                  </c:pt>
                  <c:pt idx="11">
                    <c:v>0</c:v>
                  </c:pt>
                  <c:pt idx="12">
                    <c:v>0.09</c:v>
                  </c:pt>
                  <c:pt idx="13">
                    <c:v>0</c:v>
                  </c:pt>
                  <c:pt idx="14">
                    <c:v>0.2</c:v>
                  </c:pt>
                  <c:pt idx="15">
                    <c:v>0.42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.05</c:v>
                  </c:pt>
                  <c:pt idx="21">
                    <c:v>0</c:v>
                  </c:pt>
                  <c:pt idx="22">
                    <c:v>0</c:v>
                  </c:pt>
                  <c:pt idx="23">
                    <c:v>0</c:v>
                  </c:pt>
                  <c:pt idx="24">
                    <c:v>0.3</c:v>
                  </c:pt>
                  <c:pt idx="25">
                    <c:v>0.19</c:v>
                  </c:pt>
                  <c:pt idx="26">
                    <c:v>0.25</c:v>
                  </c:pt>
                  <c:pt idx="27">
                    <c:v>0.09</c:v>
                  </c:pt>
                  <c:pt idx="28">
                    <c:v>0.27</c:v>
                  </c:pt>
                  <c:pt idx="29">
                    <c:v>0.21</c:v>
                  </c:pt>
                  <c:pt idx="30">
                    <c:v>0</c:v>
                  </c:pt>
                  <c:pt idx="31">
                    <c:v>0</c:v>
                  </c:pt>
                  <c:pt idx="32">
                    <c:v>0.09</c:v>
                  </c:pt>
                  <c:pt idx="33">
                    <c:v>0</c:v>
                  </c:pt>
                  <c:pt idx="34">
                    <c:v>0</c:v>
                  </c:pt>
                  <c:pt idx="35">
                    <c:v>0</c:v>
                  </c:pt>
                  <c:pt idx="36">
                    <c:v>0</c:v>
                  </c:pt>
                  <c:pt idx="37">
                    <c:v>0</c:v>
                  </c:pt>
                </c:numCache>
              </c:numRef>
            </c:minus>
          </c:errBars>
          <c:cat>
            <c:strRef>
              <c:f>'lipid-disprot-iupred (4)'!$BI$2:$BI$39</c:f>
              <c:strCache>
                <c:ptCount val="38"/>
                <c:pt idx="0">
                  <c:v>N-palmitoyl cysteine (-0.97)</c:v>
                </c:pt>
                <c:pt idx="1">
                  <c:v>S-diacylglycerol cysteine (-0.97)</c:v>
                </c:pt>
                <c:pt idx="2">
                  <c:v>N-myristoyl glycine (-0.17)</c:v>
                </c:pt>
                <c:pt idx="3">
                  <c:v>N-palmitoyl glycine (-1)</c:v>
                </c:pt>
                <c:pt idx="4">
                  <c:v>S-archaeol cysteine (-1)</c:v>
                </c:pt>
                <c:pt idx="5">
                  <c:v>N-(12-oxomyristoyl)cysteine (-1)</c:v>
                </c:pt>
                <c:pt idx="6">
                  <c:v>N-[(12R)-12-hydroxymyristoyl]cysteine (-1)</c:v>
                </c:pt>
                <c:pt idx="7">
                  <c:v>S-palmitoyl cysteine (-0.4)</c:v>
                </c:pt>
                <c:pt idx="8">
                  <c:v>S-geranylgeranyl cysteine (-0.78)</c:v>
                </c:pt>
                <c:pt idx="9">
                  <c:v>S-farnesyl cysteine (-0.85)</c:v>
                </c:pt>
                <c:pt idx="10">
                  <c:v>O-palmitoyl serine (0.9)</c:v>
                </c:pt>
                <c:pt idx="11">
                  <c:v>N6-myristoyl lysine (-0.93)</c:v>
                </c:pt>
                <c:pt idx="12">
                  <c:v>N6-palmitoyl lysine (-0.54)</c:v>
                </c:pt>
                <c:pt idx="13">
                  <c:v>O-octanoyl serine (-1)</c:v>
                </c:pt>
                <c:pt idx="14">
                  <c:v>S-stearoyl cysteine (0.45)</c:v>
                </c:pt>
                <c:pt idx="15">
                  <c:v>S-(15-deoxy-Delta12,14-prostaglandin J2-9-yl)cysteine (0.4)</c:v>
                </c:pt>
                <c:pt idx="16">
                  <c:v>Omega-hydroxyceramide glutamate ester (-1)</c:v>
                </c:pt>
                <c:pt idx="17">
                  <c:v>O-decanoyl serine (-1)</c:v>
                </c:pt>
                <c:pt idx="18">
                  <c:v>O-palmitoyl threonine (-1)</c:v>
                </c:pt>
                <c:pt idx="19">
                  <c:v>3'-geranyl-2',N2-cyclotryptophan (-1)</c:v>
                </c:pt>
                <c:pt idx="20">
                  <c:v>Cis-14-hydroxy-10,13-dioxo-7-heptadecenoic acid aspartate ester (1)</c:v>
                </c:pt>
                <c:pt idx="21">
                  <c:v>S-12-hydroxyfarnesyl cysteine (-1)</c:v>
                </c:pt>
                <c:pt idx="22">
                  <c:v>O-decanoyl threonine (-1)</c:v>
                </c:pt>
                <c:pt idx="23">
                  <c:v>O-octanoyl threonine (-1)</c:v>
                </c:pt>
                <c:pt idx="24">
                  <c:v>GPI-anchor amidated serine (-0.61)</c:v>
                </c:pt>
                <c:pt idx="25">
                  <c:v>GPI-anchor amidated asparagine (-0.81)</c:v>
                </c:pt>
                <c:pt idx="26">
                  <c:v>GPI-anchor amidated glycine (-0.79)</c:v>
                </c:pt>
                <c:pt idx="27">
                  <c:v>GPI-anchor amidated alanine (-0.28)</c:v>
                </c:pt>
                <c:pt idx="28">
                  <c:v>Phosphatidylethanolamine amidated glycine (1)</c:v>
                </c:pt>
                <c:pt idx="29">
                  <c:v>GPI-anchor amidated aspartate (-0.44)</c:v>
                </c:pt>
                <c:pt idx="30">
                  <c:v>Cholesterol glycine ester (-1)</c:v>
                </c:pt>
                <c:pt idx="31">
                  <c:v>GPI-like-anchor amidated serine (-1)</c:v>
                </c:pt>
                <c:pt idx="32">
                  <c:v>GPI-anchor amidated cysteine (-0.6)</c:v>
                </c:pt>
                <c:pt idx="33">
                  <c:v>GPI-like-anchor amidated asparagine (-1)</c:v>
                </c:pt>
                <c:pt idx="34">
                  <c:v>GPI-like-anchor amidated alanine (-1)</c:v>
                </c:pt>
                <c:pt idx="35">
                  <c:v>GPI-like-anchor amidated glycine (-1)</c:v>
                </c:pt>
                <c:pt idx="36">
                  <c:v>GPI-anchor amidated threonine (-1)</c:v>
                </c:pt>
                <c:pt idx="37">
                  <c:v>GPI-like-anchor amidated aspartate (-1)</c:v>
                </c:pt>
              </c:strCache>
            </c:strRef>
          </c:cat>
          <c:val>
            <c:numRef>
              <c:f>'lipid-disprot-iupred (4)'!$AN$2:$AN$39</c:f>
              <c:numCache>
                <c:formatCode>General</c:formatCode>
                <c:ptCount val="38"/>
                <c:pt idx="0">
                  <c:v>0.82</c:v>
                </c:pt>
                <c:pt idx="1">
                  <c:v>0.82</c:v>
                </c:pt>
                <c:pt idx="2">
                  <c:v>1.07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53</c:v>
                </c:pt>
                <c:pt idx="8">
                  <c:v>0.62</c:v>
                </c:pt>
                <c:pt idx="9">
                  <c:v>0.16</c:v>
                </c:pt>
                <c:pt idx="10">
                  <c:v>0.16</c:v>
                </c:pt>
                <c:pt idx="11">
                  <c:v>0</c:v>
                </c:pt>
                <c:pt idx="12">
                  <c:v>0.59</c:v>
                </c:pt>
                <c:pt idx="13">
                  <c:v>0</c:v>
                </c:pt>
                <c:pt idx="14">
                  <c:v>0.42</c:v>
                </c:pt>
                <c:pt idx="15">
                  <c:v>0.36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.42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.63</c:v>
                </c:pt>
                <c:pt idx="25">
                  <c:v>0.73</c:v>
                </c:pt>
                <c:pt idx="26">
                  <c:v>1.01</c:v>
                </c:pt>
                <c:pt idx="27">
                  <c:v>0.66</c:v>
                </c:pt>
                <c:pt idx="28">
                  <c:v>0.86</c:v>
                </c:pt>
                <c:pt idx="29">
                  <c:v>0.78</c:v>
                </c:pt>
                <c:pt idx="30">
                  <c:v>0</c:v>
                </c:pt>
                <c:pt idx="31">
                  <c:v>0</c:v>
                </c:pt>
                <c:pt idx="32">
                  <c:v>0.13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610752"/>
        <c:axId val="53625216"/>
      </c:lineChart>
      <c:lineChart>
        <c:grouping val="standard"/>
        <c:varyColors val="0"/>
        <c:ser>
          <c:idx val="3"/>
          <c:order val="4"/>
          <c:tx>
            <c:strRef>
              <c:f>'lipid-disprot-iupred (4)'!$E$1</c:f>
              <c:strCache>
                <c:ptCount val="1"/>
                <c:pt idx="0">
                  <c:v>total Nb of PTMs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noFill/>
              </a:ln>
            </c:spPr>
          </c:marker>
          <c:cat>
            <c:strRef>
              <c:f>'lipid-disprot-iupred (4)'!$BI$2:$BI$39</c:f>
              <c:strCache>
                <c:ptCount val="38"/>
                <c:pt idx="0">
                  <c:v>N-palmitoyl cysteine (-0.97)</c:v>
                </c:pt>
                <c:pt idx="1">
                  <c:v>S-diacylglycerol cysteine (-0.97)</c:v>
                </c:pt>
                <c:pt idx="2">
                  <c:v>N-myristoyl glycine (-0.17)</c:v>
                </c:pt>
                <c:pt idx="3">
                  <c:v>N-palmitoyl glycine (-1)</c:v>
                </c:pt>
                <c:pt idx="4">
                  <c:v>S-archaeol cysteine (-1)</c:v>
                </c:pt>
                <c:pt idx="5">
                  <c:v>N-(12-oxomyristoyl)cysteine (-1)</c:v>
                </c:pt>
                <c:pt idx="6">
                  <c:v>N-[(12R)-12-hydroxymyristoyl]cysteine (-1)</c:v>
                </c:pt>
                <c:pt idx="7">
                  <c:v>S-palmitoyl cysteine (-0.4)</c:v>
                </c:pt>
                <c:pt idx="8">
                  <c:v>S-geranylgeranyl cysteine (-0.78)</c:v>
                </c:pt>
                <c:pt idx="9">
                  <c:v>S-farnesyl cysteine (-0.85)</c:v>
                </c:pt>
                <c:pt idx="10">
                  <c:v>O-palmitoyl serine (0.9)</c:v>
                </c:pt>
                <c:pt idx="11">
                  <c:v>N6-myristoyl lysine (-0.93)</c:v>
                </c:pt>
                <c:pt idx="12">
                  <c:v>N6-palmitoyl lysine (-0.54)</c:v>
                </c:pt>
                <c:pt idx="13">
                  <c:v>O-octanoyl serine (-1)</c:v>
                </c:pt>
                <c:pt idx="14">
                  <c:v>S-stearoyl cysteine (0.45)</c:v>
                </c:pt>
                <c:pt idx="15">
                  <c:v>S-(15-deoxy-Delta12,14-prostaglandin J2-9-yl)cysteine (0.4)</c:v>
                </c:pt>
                <c:pt idx="16">
                  <c:v>Omega-hydroxyceramide glutamate ester (-1)</c:v>
                </c:pt>
                <c:pt idx="17">
                  <c:v>O-decanoyl serine (-1)</c:v>
                </c:pt>
                <c:pt idx="18">
                  <c:v>O-palmitoyl threonine (-1)</c:v>
                </c:pt>
                <c:pt idx="19">
                  <c:v>3'-geranyl-2',N2-cyclotryptophan (-1)</c:v>
                </c:pt>
                <c:pt idx="20">
                  <c:v>Cis-14-hydroxy-10,13-dioxo-7-heptadecenoic acid aspartate ester (1)</c:v>
                </c:pt>
                <c:pt idx="21">
                  <c:v>S-12-hydroxyfarnesyl cysteine (-1)</c:v>
                </c:pt>
                <c:pt idx="22">
                  <c:v>O-decanoyl threonine (-1)</c:v>
                </c:pt>
                <c:pt idx="23">
                  <c:v>O-octanoyl threonine (-1)</c:v>
                </c:pt>
                <c:pt idx="24">
                  <c:v>GPI-anchor amidated serine (-0.61)</c:v>
                </c:pt>
                <c:pt idx="25">
                  <c:v>GPI-anchor amidated asparagine (-0.81)</c:v>
                </c:pt>
                <c:pt idx="26">
                  <c:v>GPI-anchor amidated glycine (-0.79)</c:v>
                </c:pt>
                <c:pt idx="27">
                  <c:v>GPI-anchor amidated alanine (-0.28)</c:v>
                </c:pt>
                <c:pt idx="28">
                  <c:v>Phosphatidylethanolamine amidated glycine (1)</c:v>
                </c:pt>
                <c:pt idx="29">
                  <c:v>GPI-anchor amidated aspartate (-0.44)</c:v>
                </c:pt>
                <c:pt idx="30">
                  <c:v>Cholesterol glycine ester (-1)</c:v>
                </c:pt>
                <c:pt idx="31">
                  <c:v>GPI-like-anchor amidated serine (-1)</c:v>
                </c:pt>
                <c:pt idx="32">
                  <c:v>GPI-anchor amidated cysteine (-0.6)</c:v>
                </c:pt>
                <c:pt idx="33">
                  <c:v>GPI-like-anchor amidated asparagine (-1)</c:v>
                </c:pt>
                <c:pt idx="34">
                  <c:v>GPI-like-anchor amidated alanine (-1)</c:v>
                </c:pt>
                <c:pt idx="35">
                  <c:v>GPI-like-anchor amidated glycine (-1)</c:v>
                </c:pt>
                <c:pt idx="36">
                  <c:v>GPI-anchor amidated threonine (-1)</c:v>
                </c:pt>
                <c:pt idx="37">
                  <c:v>GPI-like-anchor amidated aspartate (-1)</c:v>
                </c:pt>
              </c:strCache>
            </c:strRef>
          </c:cat>
          <c:val>
            <c:numRef>
              <c:f>'lipid-disprot-iupred (4)'!$E$2:$E$39</c:f>
              <c:numCache>
                <c:formatCode>General</c:formatCode>
                <c:ptCount val="38"/>
                <c:pt idx="0">
                  <c:v>2058</c:v>
                </c:pt>
                <c:pt idx="1">
                  <c:v>2030</c:v>
                </c:pt>
                <c:pt idx="2">
                  <c:v>1443</c:v>
                </c:pt>
                <c:pt idx="3">
                  <c:v>18</c:v>
                </c:pt>
                <c:pt idx="4">
                  <c:v>12</c:v>
                </c:pt>
                <c:pt idx="5">
                  <c:v>1</c:v>
                </c:pt>
                <c:pt idx="6">
                  <c:v>1</c:v>
                </c:pt>
                <c:pt idx="7">
                  <c:v>3619</c:v>
                </c:pt>
                <c:pt idx="8">
                  <c:v>1096</c:v>
                </c:pt>
                <c:pt idx="9">
                  <c:v>369</c:v>
                </c:pt>
                <c:pt idx="10">
                  <c:v>164</c:v>
                </c:pt>
                <c:pt idx="11">
                  <c:v>56</c:v>
                </c:pt>
                <c:pt idx="12">
                  <c:v>13</c:v>
                </c:pt>
                <c:pt idx="13">
                  <c:v>12</c:v>
                </c:pt>
                <c:pt idx="14">
                  <c:v>11</c:v>
                </c:pt>
                <c:pt idx="15">
                  <c:v>10</c:v>
                </c:pt>
                <c:pt idx="16">
                  <c:v>9</c:v>
                </c:pt>
                <c:pt idx="17">
                  <c:v>6</c:v>
                </c:pt>
                <c:pt idx="18">
                  <c:v>5</c:v>
                </c:pt>
                <c:pt idx="19">
                  <c:v>2</c:v>
                </c:pt>
                <c:pt idx="20">
                  <c:v>2</c:v>
                </c:pt>
                <c:pt idx="21">
                  <c:v>2</c:v>
                </c:pt>
                <c:pt idx="22">
                  <c:v>1</c:v>
                </c:pt>
                <c:pt idx="23">
                  <c:v>1</c:v>
                </c:pt>
                <c:pt idx="24">
                  <c:v>378</c:v>
                </c:pt>
                <c:pt idx="25">
                  <c:v>167</c:v>
                </c:pt>
                <c:pt idx="26">
                  <c:v>164</c:v>
                </c:pt>
                <c:pt idx="27">
                  <c:v>89</c:v>
                </c:pt>
                <c:pt idx="28">
                  <c:v>81</c:v>
                </c:pt>
                <c:pt idx="29">
                  <c:v>50</c:v>
                </c:pt>
                <c:pt idx="30">
                  <c:v>30</c:v>
                </c:pt>
                <c:pt idx="31">
                  <c:v>16</c:v>
                </c:pt>
                <c:pt idx="32">
                  <c:v>15</c:v>
                </c:pt>
                <c:pt idx="33">
                  <c:v>15</c:v>
                </c:pt>
                <c:pt idx="34">
                  <c:v>7</c:v>
                </c:pt>
                <c:pt idx="35">
                  <c:v>4</c:v>
                </c:pt>
                <c:pt idx="36">
                  <c:v>1</c:v>
                </c:pt>
                <c:pt idx="37">
                  <c:v>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3645312"/>
        <c:axId val="53626752"/>
      </c:lineChart>
      <c:catAx>
        <c:axId val="53610752"/>
        <c:scaling>
          <c:orientation val="minMax"/>
        </c:scaling>
        <c:delete val="0"/>
        <c:axPos val="b"/>
        <c:majorTickMark val="out"/>
        <c:minorTickMark val="none"/>
        <c:tickLblPos val="low"/>
        <c:txPr>
          <a:bodyPr/>
          <a:lstStyle/>
          <a:p>
            <a:pPr>
              <a:defRPr sz="900"/>
            </a:pPr>
            <a:endParaRPr lang="de-DE"/>
          </a:p>
        </c:txPr>
        <c:crossAx val="53625216"/>
        <c:crosses val="autoZero"/>
        <c:auto val="1"/>
        <c:lblAlgn val="ctr"/>
        <c:lblOffset val="100"/>
        <c:noMultiLvlLbl val="0"/>
      </c:catAx>
      <c:valAx>
        <c:axId val="53625216"/>
        <c:scaling>
          <c:orientation val="minMax"/>
        </c:scaling>
        <c:delete val="0"/>
        <c:axPos val="l"/>
        <c:majorGridlines/>
        <c:numFmt formatCode="0%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de-DE"/>
          </a:p>
        </c:txPr>
        <c:crossAx val="53610752"/>
        <c:crosses val="autoZero"/>
        <c:crossBetween val="between"/>
      </c:valAx>
      <c:valAx>
        <c:axId val="53626752"/>
        <c:scaling>
          <c:orientation val="minMax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Total Number</a:t>
                </a:r>
                <a:r>
                  <a:rPr lang="en-US" sz="1200" baseline="0"/>
                  <a:t> of PTMs</a:t>
                </a:r>
                <a:endParaRPr lang="en-US" sz="12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de-DE"/>
          </a:p>
        </c:txPr>
        <c:crossAx val="53645312"/>
        <c:crosses val="max"/>
        <c:crossBetween val="between"/>
        <c:majorUnit val="400"/>
      </c:valAx>
      <c:catAx>
        <c:axId val="53645312"/>
        <c:scaling>
          <c:orientation val="minMax"/>
        </c:scaling>
        <c:delete val="1"/>
        <c:axPos val="b"/>
        <c:majorTickMark val="out"/>
        <c:minorTickMark val="none"/>
        <c:tickLblPos val="none"/>
        <c:crossAx val="53626752"/>
        <c:crosses val="autoZero"/>
        <c:auto val="1"/>
        <c:lblAlgn val="ctr"/>
        <c:lblOffset val="100"/>
        <c:noMultiLvlLbl val="0"/>
      </c:catAx>
    </c:plotArea>
    <c:legend>
      <c:legendPos val="t"/>
      <c:layout/>
      <c:overlay val="0"/>
      <c:txPr>
        <a:bodyPr/>
        <a:lstStyle/>
        <a:p>
          <a:pPr>
            <a:defRPr sz="1000"/>
          </a:pPr>
          <a:endParaRPr lang="de-DE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8D124E-85D2-4D97-91BD-71A761A303FF}" type="datetimeFigureOut">
              <a:rPr lang="en-US"/>
              <a:pPr>
                <a:defRPr/>
              </a:pPr>
              <a:t>5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42E1E5-DC65-443F-BB9C-0742856AD68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762F5B-3BF0-4E7D-9176-B2C35AFB9584}" type="datetimeFigureOut">
              <a:rPr lang="en-US"/>
              <a:pPr>
                <a:defRPr/>
              </a:pPr>
              <a:t>5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212225-0849-4AC2-9BA5-22B16B97865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4B5AB8-83AE-40FC-ABCC-89F02F8FAA65}" type="datetimeFigureOut">
              <a:rPr lang="en-US"/>
              <a:pPr>
                <a:defRPr/>
              </a:pPr>
              <a:t>5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8CEF03-7554-4D32-B049-9DA503FF2BA5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BCA90F-93AD-476E-8770-0D8E13638E10}" type="datetimeFigureOut">
              <a:rPr lang="en-US"/>
              <a:pPr>
                <a:defRPr/>
              </a:pPr>
              <a:t>5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A1CD8C-E2CE-4EE1-8311-F89ED6D6673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B6CC19-83A8-4315-91F3-5CCCAF2522EF}" type="datetimeFigureOut">
              <a:rPr lang="en-US"/>
              <a:pPr>
                <a:defRPr/>
              </a:pPr>
              <a:t>5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466D1F-007E-4DAD-8268-81AA5B98035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0426E1-5A9E-422B-83EB-E60B5D7FA3FE}" type="datetimeFigureOut">
              <a:rPr lang="en-US"/>
              <a:pPr>
                <a:defRPr/>
              </a:pPr>
              <a:t>5/19/20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258C87-C146-4244-A8B1-1BAE757FDC7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9C4539-50CC-48DD-90E8-C1646B204C9D}" type="datetimeFigureOut">
              <a:rPr lang="en-US"/>
              <a:pPr>
                <a:defRPr/>
              </a:pPr>
              <a:t>5/19/2015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90FDE6-9CD7-4558-A1B7-250A3B65CDF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AD5216-E64A-4BC8-83CB-6380113F4168}" type="datetimeFigureOut">
              <a:rPr lang="en-US"/>
              <a:pPr>
                <a:defRPr/>
              </a:pPr>
              <a:t>5/19/2015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0E0B01-7BDE-4AC7-8B22-A2416CDCF653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2DBEE9-F788-4AB9-BBE0-7ECD3BDFEA96}" type="datetimeFigureOut">
              <a:rPr lang="en-US"/>
              <a:pPr>
                <a:defRPr/>
              </a:pPr>
              <a:t>5/19/2015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21D23F-4DA4-45F1-895C-CA735CB6CF05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F66732-E331-477B-B809-6899A9831454}" type="datetimeFigureOut">
              <a:rPr lang="en-US"/>
              <a:pPr>
                <a:defRPr/>
              </a:pPr>
              <a:t>5/19/20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4444A4-CF12-4C18-8FC2-BF085B554C7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E418DC-61CE-4500-8FCC-6A9D12FAC69A}" type="datetimeFigureOut">
              <a:rPr lang="en-US"/>
              <a:pPr>
                <a:defRPr/>
              </a:pPr>
              <a:t>5/19/20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5F3D86-9B72-4F8C-8DDA-18E9497B566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95300" y="274638"/>
            <a:ext cx="8915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95300" y="1600200"/>
            <a:ext cx="89154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0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AAB5F9FD-6F8A-47E0-92EA-6C129FB0CE5B}" type="datetimeFigureOut">
              <a:rPr lang="en-US"/>
              <a:pPr>
                <a:defRPr/>
              </a:pPr>
              <a:t>5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0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EA744711-1E7D-4510-B02D-16D7AD298495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Box 2"/>
          <p:cNvSpPr txBox="1">
            <a:spLocks noChangeArrowheads="1"/>
          </p:cNvSpPr>
          <p:nvPr/>
        </p:nvSpPr>
        <p:spPr bwMode="auto">
          <a:xfrm>
            <a:off x="3581400" y="6488113"/>
            <a:ext cx="2743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b="1">
                <a:latin typeface="Calibri" pitchFamily="34" charset="0"/>
              </a:rPr>
              <a:t>Supplementary Figure 1</a:t>
            </a:r>
          </a:p>
        </p:txBody>
      </p:sp>
      <p:pic>
        <p:nvPicPr>
          <p:cNvPr id="2051" name="Picture 3" descr="Phosphatidylethanolanime_amidated_glycine_ALL2.png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9525"/>
            <a:ext cx="9753600" cy="6838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TextBox 1"/>
          <p:cNvSpPr txBox="1">
            <a:spLocks noChangeArrowheads="1"/>
          </p:cNvSpPr>
          <p:nvPr/>
        </p:nvSpPr>
        <p:spPr bwMode="auto">
          <a:xfrm>
            <a:off x="3581400" y="6488113"/>
            <a:ext cx="2743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b="1" dirty="0">
                <a:latin typeface="Calibri" pitchFamily="34" charset="0"/>
              </a:rPr>
              <a:t>Supplementary Figure </a:t>
            </a:r>
            <a:r>
              <a:rPr lang="en-US" altLang="en-US" b="1" dirty="0" smtClean="0">
                <a:latin typeface="Calibri" pitchFamily="34" charset="0"/>
              </a:rPr>
              <a:t>10</a:t>
            </a:r>
            <a:endParaRPr lang="en-US" altLang="en-US" b="1" dirty="0">
              <a:latin typeface="Calibri" pitchFamily="34" charset="0"/>
            </a:endParaRPr>
          </a:p>
        </p:txBody>
      </p:sp>
      <p:pic>
        <p:nvPicPr>
          <p:cNvPr id="10243" name="Picture 7" descr="N6-(36-diaminohexanoyl)-5-hydroxylysine_3a5z.png"/>
          <p:cNvPicPr>
            <a:picLocks noChangeAspect="1"/>
          </p:cNvPicPr>
          <p:nvPr/>
        </p:nvPicPr>
        <p:blipFill>
          <a:blip r:embed="rId2" cstate="print"/>
          <a:srcRect l="15625" r="25781"/>
          <a:stretch>
            <a:fillRect/>
          </a:stretch>
        </p:blipFill>
        <p:spPr bwMode="auto">
          <a:xfrm>
            <a:off x="152400" y="304800"/>
            <a:ext cx="5715000" cy="5600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44" name="Picture 8" descr="N6-(36-diaminohexanoyl)-5-hydroxylysine_3tre.png"/>
          <p:cNvPicPr>
            <a:picLocks noChangeAspect="1"/>
          </p:cNvPicPr>
          <p:nvPr/>
        </p:nvPicPr>
        <p:blipFill>
          <a:blip r:embed="rId3" cstate="print"/>
          <a:srcRect l="30469" r="23438"/>
          <a:stretch>
            <a:fillRect/>
          </a:stretch>
        </p:blipFill>
        <p:spPr bwMode="auto">
          <a:xfrm>
            <a:off x="5181600" y="304800"/>
            <a:ext cx="4495800" cy="5600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245" name="TextBox 13"/>
          <p:cNvSpPr txBox="1">
            <a:spLocks noChangeArrowheads="1"/>
          </p:cNvSpPr>
          <p:nvPr/>
        </p:nvSpPr>
        <p:spPr bwMode="auto">
          <a:xfrm>
            <a:off x="2209800" y="5402263"/>
            <a:ext cx="974725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>
                <a:latin typeface="Calibri" pitchFamily="34" charset="0"/>
              </a:rPr>
              <a:t>(</a:t>
            </a:r>
            <a:r>
              <a:rPr lang="pt-BR" altLang="en-US" i="1">
                <a:latin typeface="Cambria" pitchFamily="18" charset="0"/>
              </a:rPr>
              <a:t>a</a:t>
            </a:r>
            <a:r>
              <a:rPr lang="pt-BR" altLang="en-US">
                <a:latin typeface="Calibri" pitchFamily="34" charset="0"/>
              </a:rPr>
              <a:t>) 3A5Z</a:t>
            </a:r>
          </a:p>
        </p:txBody>
      </p:sp>
      <p:sp>
        <p:nvSpPr>
          <p:cNvPr id="10246" name="TextBox 14"/>
          <p:cNvSpPr txBox="1">
            <a:spLocks noChangeArrowheads="1"/>
          </p:cNvSpPr>
          <p:nvPr/>
        </p:nvSpPr>
        <p:spPr bwMode="auto">
          <a:xfrm>
            <a:off x="7162800" y="5402263"/>
            <a:ext cx="966788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>
                <a:latin typeface="Calibri" pitchFamily="34" charset="0"/>
              </a:rPr>
              <a:t>(</a:t>
            </a:r>
            <a:r>
              <a:rPr lang="pt-BR" altLang="en-US" i="1">
                <a:latin typeface="Cambria" pitchFamily="18" charset="0"/>
              </a:rPr>
              <a:t>b</a:t>
            </a:r>
            <a:r>
              <a:rPr lang="pt-BR" altLang="en-US">
                <a:latin typeface="Calibri" pitchFamily="34" charset="0"/>
              </a:rPr>
              <a:t>) 3TRE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6" descr="ptm_methasp.png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909638"/>
            <a:ext cx="9753600" cy="5038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267" name="TextBox 1"/>
          <p:cNvSpPr txBox="1">
            <a:spLocks noChangeArrowheads="1"/>
          </p:cNvSpPr>
          <p:nvPr/>
        </p:nvSpPr>
        <p:spPr bwMode="auto">
          <a:xfrm>
            <a:off x="3581400" y="6488113"/>
            <a:ext cx="2743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b="1" dirty="0">
                <a:latin typeface="Calibri" pitchFamily="34" charset="0"/>
              </a:rPr>
              <a:t>Supplementary Figure </a:t>
            </a:r>
            <a:r>
              <a:rPr lang="en-US" altLang="en-US" b="1" dirty="0" smtClean="0">
                <a:latin typeface="Calibri" pitchFamily="34" charset="0"/>
              </a:rPr>
              <a:t>11</a:t>
            </a:r>
            <a:endParaRPr lang="en-US" altLang="en-US" b="1" dirty="0">
              <a:latin typeface="Calibri" pitchFamily="34" charset="0"/>
            </a:endParaRPr>
          </a:p>
        </p:txBody>
      </p:sp>
      <p:sp>
        <p:nvSpPr>
          <p:cNvPr id="11268" name="TextBox 14"/>
          <p:cNvSpPr txBox="1">
            <a:spLocks noChangeArrowheads="1"/>
          </p:cNvSpPr>
          <p:nvPr/>
        </p:nvSpPr>
        <p:spPr bwMode="auto">
          <a:xfrm>
            <a:off x="2286000" y="457200"/>
            <a:ext cx="5422900" cy="646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>
                <a:latin typeface="Courier New" pitchFamily="49" charset="0"/>
                <a:cs typeface="Courier New" pitchFamily="49" charset="0"/>
              </a:rPr>
              <a:t>1B33: methylated asparagine (red)</a:t>
            </a:r>
          </a:p>
          <a:p>
            <a:r>
              <a:rPr lang="pt-BR" altLang="en-US">
                <a:latin typeface="Courier New" pitchFamily="49" charset="0"/>
                <a:cs typeface="Courier New" pitchFamily="49" charset="0"/>
              </a:rPr>
              <a:t>1ON7: unmethylated asparagine (yellow)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7" name="TextBox 1"/>
          <p:cNvSpPr txBox="1">
            <a:spLocks noChangeArrowheads="1"/>
          </p:cNvSpPr>
          <p:nvPr/>
        </p:nvSpPr>
        <p:spPr bwMode="auto">
          <a:xfrm>
            <a:off x="3581400" y="6488113"/>
            <a:ext cx="2743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b="1" dirty="0">
                <a:latin typeface="Calibri" pitchFamily="34" charset="0"/>
              </a:rPr>
              <a:t>Supplementary Figure </a:t>
            </a:r>
            <a:r>
              <a:rPr lang="en-US" altLang="en-US" b="1" dirty="0" smtClean="0">
                <a:latin typeface="Calibri" pitchFamily="34" charset="0"/>
              </a:rPr>
              <a:t>12</a:t>
            </a:r>
            <a:endParaRPr lang="en-US" altLang="en-US" b="1" dirty="0">
              <a:latin typeface="Calibri" pitchFamily="34" charset="0"/>
            </a:endParaRPr>
          </a:p>
        </p:txBody>
      </p:sp>
      <p:graphicFrame>
        <p:nvGraphicFramePr>
          <p:cNvPr id="5" name="Chart 4"/>
          <p:cNvGraphicFramePr/>
          <p:nvPr/>
        </p:nvGraphicFramePr>
        <p:xfrm>
          <a:off x="457200" y="380999"/>
          <a:ext cx="8915400" cy="5715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7" name="TextBox 1"/>
          <p:cNvSpPr txBox="1">
            <a:spLocks noChangeArrowheads="1"/>
          </p:cNvSpPr>
          <p:nvPr/>
        </p:nvSpPr>
        <p:spPr bwMode="auto">
          <a:xfrm>
            <a:off x="3581400" y="6488113"/>
            <a:ext cx="2743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b="1" dirty="0">
                <a:latin typeface="Calibri" pitchFamily="34" charset="0"/>
              </a:rPr>
              <a:t>Supplementary Figure </a:t>
            </a:r>
            <a:r>
              <a:rPr lang="en-US" altLang="en-US" b="1" dirty="0" smtClean="0">
                <a:latin typeface="Calibri" pitchFamily="34" charset="0"/>
              </a:rPr>
              <a:t>13</a:t>
            </a:r>
            <a:endParaRPr lang="en-US" altLang="en-US" b="1" dirty="0">
              <a:latin typeface="Calibri" pitchFamily="34" charset="0"/>
            </a:endParaRPr>
          </a:p>
        </p:txBody>
      </p:sp>
      <p:graphicFrame>
        <p:nvGraphicFramePr>
          <p:cNvPr id="4" name="Chart 3"/>
          <p:cNvGraphicFramePr/>
          <p:nvPr/>
        </p:nvGraphicFramePr>
        <p:xfrm>
          <a:off x="563880" y="152400"/>
          <a:ext cx="8778240" cy="6217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Box 1"/>
          <p:cNvSpPr txBox="1">
            <a:spLocks noChangeArrowheads="1"/>
          </p:cNvSpPr>
          <p:nvPr/>
        </p:nvSpPr>
        <p:spPr bwMode="auto">
          <a:xfrm>
            <a:off x="3581400" y="6488113"/>
            <a:ext cx="2743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b="1" dirty="0">
                <a:latin typeface="Calibri" pitchFamily="34" charset="0"/>
              </a:rPr>
              <a:t>Supplementary Figure </a:t>
            </a:r>
            <a:r>
              <a:rPr lang="en-US" altLang="en-US" b="1" dirty="0" smtClean="0">
                <a:latin typeface="Calibri" pitchFamily="34" charset="0"/>
              </a:rPr>
              <a:t>2</a:t>
            </a:r>
            <a:endParaRPr lang="en-US" altLang="en-US" b="1" dirty="0">
              <a:latin typeface="Calibri" pitchFamily="34" charset="0"/>
            </a:endParaRPr>
          </a:p>
        </p:txBody>
      </p:sp>
      <p:pic>
        <p:nvPicPr>
          <p:cNvPr id="4099" name="Picture 2" descr="farnesyl-cys-RAS-4pdbs_v2.png"/>
          <p:cNvPicPr>
            <a:picLocks noChangeAspect="1"/>
          </p:cNvPicPr>
          <p:nvPr/>
        </p:nvPicPr>
        <p:blipFill>
          <a:blip r:embed="rId2" cstate="print"/>
          <a:srcRect l="5469" t="3203" r="7813" b="5432"/>
          <a:stretch>
            <a:fillRect/>
          </a:stretch>
        </p:blipFill>
        <p:spPr bwMode="auto">
          <a:xfrm>
            <a:off x="609600" y="228600"/>
            <a:ext cx="8458200" cy="6248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5" name="Straight Arrow Connector 4"/>
          <p:cNvCxnSpPr/>
          <p:nvPr/>
        </p:nvCxnSpPr>
        <p:spPr>
          <a:xfrm flipH="1">
            <a:off x="2895600" y="3048000"/>
            <a:ext cx="1447800" cy="1143000"/>
          </a:xfrm>
          <a:prstGeom prst="straightConnector1">
            <a:avLst/>
          </a:prstGeom>
          <a:ln>
            <a:solidFill>
              <a:schemeClr val="tx1"/>
            </a:solidFill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01" name="TextBox 6"/>
          <p:cNvSpPr txBox="1">
            <a:spLocks noChangeArrowheads="1"/>
          </p:cNvSpPr>
          <p:nvPr/>
        </p:nvSpPr>
        <p:spPr bwMode="auto">
          <a:xfrm>
            <a:off x="2144713" y="4038600"/>
            <a:ext cx="1317625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400">
                <a:latin typeface="Calibri" pitchFamily="34" charset="0"/>
              </a:rPr>
              <a:t>Cys 105</a:t>
            </a:r>
          </a:p>
          <a:p>
            <a:r>
              <a:rPr lang="pt-BR" altLang="en-US" sz="1400">
                <a:latin typeface="Calibri" pitchFamily="34" charset="0"/>
              </a:rPr>
              <a:t>Cys 107 in 4F38</a:t>
            </a:r>
            <a:endParaRPr lang="en-US" altLang="en-US" sz="1400">
              <a:latin typeface="Calibri" pitchFamily="34" charset="0"/>
            </a:endParaRPr>
          </a:p>
        </p:txBody>
      </p:sp>
      <p:sp>
        <p:nvSpPr>
          <p:cNvPr id="4102" name="TextBox 7"/>
          <p:cNvSpPr txBox="1">
            <a:spLocks noChangeArrowheads="1"/>
          </p:cNvSpPr>
          <p:nvPr/>
        </p:nvSpPr>
        <p:spPr bwMode="auto">
          <a:xfrm>
            <a:off x="4287838" y="609600"/>
            <a:ext cx="744537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400">
                <a:latin typeface="Calibri" pitchFamily="34" charset="0"/>
              </a:rPr>
              <a:t>Cys 188</a:t>
            </a:r>
            <a:endParaRPr lang="en-US" altLang="en-US" sz="1400">
              <a:latin typeface="Calibri" pitchFamily="34" charset="0"/>
            </a:endParaRPr>
          </a:p>
        </p:txBody>
      </p:sp>
      <p:cxnSp>
        <p:nvCxnSpPr>
          <p:cNvPr id="9" name="Straight Arrow Connector 8"/>
          <p:cNvCxnSpPr>
            <a:endCxn id="4102" idx="2"/>
          </p:cNvCxnSpPr>
          <p:nvPr/>
        </p:nvCxnSpPr>
        <p:spPr>
          <a:xfrm flipH="1" flipV="1">
            <a:off x="4660900" y="917575"/>
            <a:ext cx="63500" cy="1597025"/>
          </a:xfrm>
          <a:prstGeom prst="straightConnector1">
            <a:avLst/>
          </a:prstGeom>
          <a:ln>
            <a:solidFill>
              <a:schemeClr val="tx1"/>
            </a:solidFill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1752600" y="2438400"/>
            <a:ext cx="0" cy="609600"/>
          </a:xfrm>
          <a:prstGeom prst="straightConnector1">
            <a:avLst/>
          </a:prstGeom>
          <a:ln>
            <a:solidFill>
              <a:schemeClr val="tx1"/>
            </a:solidFill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05" name="TextBox 16"/>
          <p:cNvSpPr txBox="1">
            <a:spLocks noChangeArrowheads="1"/>
          </p:cNvSpPr>
          <p:nvPr/>
        </p:nvSpPr>
        <p:spPr bwMode="auto">
          <a:xfrm>
            <a:off x="1409700" y="2992438"/>
            <a:ext cx="746125" cy="522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pt-BR" altLang="en-US" sz="1400">
                <a:latin typeface="Calibri" pitchFamily="34" charset="0"/>
              </a:rPr>
              <a:t>Cys 190</a:t>
            </a:r>
          </a:p>
          <a:p>
            <a:pPr algn="ctr"/>
            <a:r>
              <a:rPr lang="pt-BR" altLang="en-US" sz="1400">
                <a:latin typeface="Calibri" pitchFamily="34" charset="0"/>
              </a:rPr>
              <a:t>in 4F38</a:t>
            </a:r>
            <a:endParaRPr lang="en-US" altLang="en-US" sz="1400">
              <a:latin typeface="Calibri" pitchFamily="34" charset="0"/>
            </a:endParaRPr>
          </a:p>
        </p:txBody>
      </p:sp>
      <p:sp>
        <p:nvSpPr>
          <p:cNvPr id="4106" name="TextBox 17"/>
          <p:cNvSpPr txBox="1">
            <a:spLocks noChangeArrowheads="1"/>
          </p:cNvSpPr>
          <p:nvPr/>
        </p:nvSpPr>
        <p:spPr bwMode="auto">
          <a:xfrm>
            <a:off x="381000" y="914400"/>
            <a:ext cx="1627188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en-US" sz="1400">
                <a:latin typeface="Calibri" pitchFamily="34" charset="0"/>
              </a:rPr>
              <a:t>GERAN-8-YL GERAN</a:t>
            </a:r>
          </a:p>
        </p:txBody>
      </p:sp>
      <p:cxnSp>
        <p:nvCxnSpPr>
          <p:cNvPr id="19" name="Straight Arrow Connector 18"/>
          <p:cNvCxnSpPr/>
          <p:nvPr/>
        </p:nvCxnSpPr>
        <p:spPr>
          <a:xfrm flipH="1" flipV="1">
            <a:off x="1447800" y="1219200"/>
            <a:ext cx="136525" cy="385763"/>
          </a:xfrm>
          <a:prstGeom prst="straightConnector1">
            <a:avLst/>
          </a:prstGeom>
          <a:ln>
            <a:solidFill>
              <a:schemeClr val="tx1"/>
            </a:solidFill>
            <a:prstDash val="sysDot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TextBox 1"/>
          <p:cNvSpPr txBox="1">
            <a:spLocks noChangeArrowheads="1"/>
          </p:cNvSpPr>
          <p:nvPr/>
        </p:nvSpPr>
        <p:spPr bwMode="auto">
          <a:xfrm>
            <a:off x="3581400" y="6488113"/>
            <a:ext cx="2743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b="1" dirty="0">
                <a:latin typeface="Calibri" pitchFamily="34" charset="0"/>
              </a:rPr>
              <a:t>Supplementary Figure </a:t>
            </a:r>
            <a:r>
              <a:rPr lang="en-US" altLang="en-US" b="1" dirty="0" smtClean="0">
                <a:latin typeface="Calibri" pitchFamily="34" charset="0"/>
              </a:rPr>
              <a:t>3</a:t>
            </a:r>
            <a:endParaRPr lang="en-US" altLang="en-US" b="1" dirty="0">
              <a:latin typeface="Calibri" pitchFamily="34" charset="0"/>
            </a:endParaRPr>
          </a:p>
        </p:txBody>
      </p:sp>
      <p:pic>
        <p:nvPicPr>
          <p:cNvPr id="12291" name="Picture 4" descr="farnesyl-cys-RAS-4dm9.png"/>
          <p:cNvPicPr>
            <a:picLocks noChangeAspect="1"/>
          </p:cNvPicPr>
          <p:nvPr/>
        </p:nvPicPr>
        <p:blipFill>
          <a:blip r:embed="rId2" cstate="print"/>
          <a:srcRect l="20313" r="21875"/>
          <a:stretch>
            <a:fillRect/>
          </a:stretch>
        </p:blipFill>
        <p:spPr bwMode="auto">
          <a:xfrm>
            <a:off x="2057400" y="628650"/>
            <a:ext cx="5638800" cy="5600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292" name="TextBox 5"/>
          <p:cNvSpPr txBox="1">
            <a:spLocks noChangeArrowheads="1"/>
          </p:cNvSpPr>
          <p:nvPr/>
        </p:nvSpPr>
        <p:spPr bwMode="auto">
          <a:xfrm>
            <a:off x="6248400" y="5105400"/>
            <a:ext cx="75882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>
                <a:latin typeface="Calibri" pitchFamily="34" charset="0"/>
              </a:rPr>
              <a:t>4DM9</a:t>
            </a:r>
          </a:p>
        </p:txBody>
      </p:sp>
      <p:sp>
        <p:nvSpPr>
          <p:cNvPr id="12293" name="TextBox 7"/>
          <p:cNvSpPr txBox="1">
            <a:spLocks noChangeArrowheads="1"/>
          </p:cNvSpPr>
          <p:nvPr/>
        </p:nvSpPr>
        <p:spPr bwMode="auto">
          <a:xfrm>
            <a:off x="2819400" y="1676400"/>
            <a:ext cx="90390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dirty="0" smtClean="0">
                <a:latin typeface="Calibri" pitchFamily="34" charset="0"/>
              </a:rPr>
              <a:t>Cys 220</a:t>
            </a:r>
            <a:endParaRPr lang="pt-BR" altLang="en-US" dirty="0">
              <a:latin typeface="Calibri" pitchFamily="34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 flipH="1" flipV="1">
            <a:off x="3352800" y="2057400"/>
            <a:ext cx="381000" cy="4572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O-palmitoyl_serine-v2.png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9525"/>
            <a:ext cx="9753600" cy="6838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123" name="TextBox 1"/>
          <p:cNvSpPr txBox="1">
            <a:spLocks noChangeArrowheads="1"/>
          </p:cNvSpPr>
          <p:nvPr/>
        </p:nvSpPr>
        <p:spPr bwMode="auto">
          <a:xfrm>
            <a:off x="3581400" y="6488113"/>
            <a:ext cx="2743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b="1" dirty="0">
                <a:latin typeface="Calibri" pitchFamily="34" charset="0"/>
              </a:rPr>
              <a:t>Supplementary Figure </a:t>
            </a:r>
            <a:r>
              <a:rPr lang="en-US" altLang="en-US" b="1" dirty="0" smtClean="0">
                <a:latin typeface="Calibri" pitchFamily="34" charset="0"/>
              </a:rPr>
              <a:t>4</a:t>
            </a:r>
            <a:endParaRPr lang="en-US" altLang="en-US" b="1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xtBox 1"/>
          <p:cNvSpPr txBox="1">
            <a:spLocks noChangeArrowheads="1"/>
          </p:cNvSpPr>
          <p:nvPr/>
        </p:nvSpPr>
        <p:spPr bwMode="auto">
          <a:xfrm>
            <a:off x="3581400" y="6488113"/>
            <a:ext cx="2743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b="1" dirty="0">
                <a:latin typeface="Calibri" pitchFamily="34" charset="0"/>
              </a:rPr>
              <a:t>Supplementary Figure </a:t>
            </a:r>
            <a:r>
              <a:rPr lang="en-US" altLang="en-US" b="1" dirty="0" smtClean="0">
                <a:latin typeface="Calibri" pitchFamily="34" charset="0"/>
              </a:rPr>
              <a:t>5</a:t>
            </a:r>
            <a:endParaRPr lang="en-US" altLang="en-US" b="1" dirty="0">
              <a:latin typeface="Calibri" pitchFamily="34" charset="0"/>
            </a:endParaRPr>
          </a:p>
        </p:txBody>
      </p:sp>
      <p:pic>
        <p:nvPicPr>
          <p:cNvPr id="6147" name="Picture 2" descr="S-stearoyl_cysteine-VIRUSES_v2.png"/>
          <p:cNvPicPr>
            <a:picLocks noChangeAspect="1"/>
          </p:cNvPicPr>
          <p:nvPr/>
        </p:nvPicPr>
        <p:blipFill>
          <a:blip r:embed="rId2" cstate="print"/>
          <a:srcRect l="17969" t="4318" r="20313" b="6546"/>
          <a:stretch>
            <a:fillRect/>
          </a:stretch>
        </p:blipFill>
        <p:spPr bwMode="auto">
          <a:xfrm>
            <a:off x="1828800" y="304800"/>
            <a:ext cx="6019800" cy="609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148" name="TextBox 3"/>
          <p:cNvSpPr txBox="1">
            <a:spLocks noChangeArrowheads="1"/>
          </p:cNvSpPr>
          <p:nvPr/>
        </p:nvSpPr>
        <p:spPr bwMode="auto">
          <a:xfrm>
            <a:off x="3524250" y="4387850"/>
            <a:ext cx="744538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400">
                <a:latin typeface="Calibri" pitchFamily="34" charset="0"/>
              </a:rPr>
              <a:t>Cys 433</a:t>
            </a:r>
            <a:endParaRPr lang="en-US" altLang="en-US" sz="140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extBox 1"/>
          <p:cNvSpPr txBox="1">
            <a:spLocks noChangeArrowheads="1"/>
          </p:cNvSpPr>
          <p:nvPr/>
        </p:nvSpPr>
        <p:spPr bwMode="auto">
          <a:xfrm>
            <a:off x="3581400" y="6488113"/>
            <a:ext cx="2743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b="1" dirty="0">
                <a:latin typeface="Calibri" pitchFamily="34" charset="0"/>
              </a:rPr>
              <a:t>Supplementary Figure </a:t>
            </a:r>
            <a:r>
              <a:rPr lang="en-US" altLang="en-US" b="1" dirty="0" smtClean="0">
                <a:latin typeface="Calibri" pitchFamily="34" charset="0"/>
              </a:rPr>
              <a:t>6</a:t>
            </a:r>
            <a:endParaRPr lang="en-US" altLang="en-US" b="1" dirty="0">
              <a:latin typeface="Calibri" pitchFamily="34" charset="0"/>
            </a:endParaRPr>
          </a:p>
        </p:txBody>
      </p:sp>
      <p:pic>
        <p:nvPicPr>
          <p:cNvPr id="7171" name="Picture 2" descr="S-stearoyl_cysteine-HUMAN_v2.png"/>
          <p:cNvPicPr>
            <a:picLocks noChangeAspect="1"/>
          </p:cNvPicPr>
          <p:nvPr/>
        </p:nvPicPr>
        <p:blipFill>
          <a:blip r:embed="rId2" cstate="print"/>
          <a:srcRect l="7813" t="4675" r="14063"/>
          <a:stretch>
            <a:fillRect/>
          </a:stretch>
        </p:blipFill>
        <p:spPr bwMode="auto">
          <a:xfrm>
            <a:off x="2362200" y="0"/>
            <a:ext cx="7620000" cy="6019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172" name="TextBox 4"/>
          <p:cNvSpPr txBox="1">
            <a:spLocks noChangeArrowheads="1"/>
          </p:cNvSpPr>
          <p:nvPr/>
        </p:nvSpPr>
        <p:spPr bwMode="auto">
          <a:xfrm>
            <a:off x="6934200" y="5029200"/>
            <a:ext cx="823913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600">
                <a:latin typeface="Calibri" pitchFamily="34" charset="0"/>
              </a:rPr>
              <a:t>Cys 288</a:t>
            </a:r>
            <a:endParaRPr lang="en-US" altLang="en-US" sz="1600">
              <a:latin typeface="Calibri" pitchFamily="34" charset="0"/>
            </a:endParaRPr>
          </a:p>
        </p:txBody>
      </p:sp>
      <p:sp>
        <p:nvSpPr>
          <p:cNvPr id="7173" name="TextBox 5"/>
          <p:cNvSpPr txBox="1">
            <a:spLocks noChangeArrowheads="1"/>
          </p:cNvSpPr>
          <p:nvPr/>
        </p:nvSpPr>
        <p:spPr bwMode="auto">
          <a:xfrm>
            <a:off x="7010400" y="4343400"/>
            <a:ext cx="823913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600">
                <a:latin typeface="Calibri" pitchFamily="34" charset="0"/>
              </a:rPr>
              <a:t>Cys 326</a:t>
            </a:r>
            <a:endParaRPr lang="en-US" altLang="en-US" sz="1600">
              <a:latin typeface="Calibri" pitchFamily="34" charset="0"/>
            </a:endParaRPr>
          </a:p>
        </p:txBody>
      </p:sp>
      <p:sp>
        <p:nvSpPr>
          <p:cNvPr id="7174" name="TextBox 6"/>
          <p:cNvSpPr txBox="1">
            <a:spLocks noChangeArrowheads="1"/>
          </p:cNvSpPr>
          <p:nvPr/>
        </p:nvSpPr>
        <p:spPr bwMode="auto">
          <a:xfrm>
            <a:off x="333375" y="1905000"/>
            <a:ext cx="3184525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 sz="1000">
                <a:latin typeface="Courier New" pitchFamily="49" charset="0"/>
                <a:cs typeface="Courier New" pitchFamily="49" charset="0"/>
              </a:rPr>
              <a:t>Query: </a:t>
            </a:r>
            <a:r>
              <a:rPr lang="en-US" altLang="en-US" sz="1000">
                <a:latin typeface="Courier New" pitchFamily="49" charset="0"/>
                <a:cs typeface="Courier New" pitchFamily="49" charset="0"/>
              </a:rPr>
              <a:t>sp|P16109|LYAM3_HUMAN P-selectin</a:t>
            </a:r>
          </a:p>
          <a:p>
            <a:r>
              <a:rPr lang="pt-BR" altLang="en-US" sz="1000">
                <a:latin typeface="Courier New" pitchFamily="49" charset="0"/>
                <a:cs typeface="Courier New" pitchFamily="49" charset="0"/>
              </a:rPr>
              <a:t>Sbjct: </a:t>
            </a:r>
            <a:r>
              <a:rPr lang="en-US" altLang="en-US" sz="1000">
                <a:latin typeface="Courier New" pitchFamily="49" charset="0"/>
                <a:cs typeface="Courier New" pitchFamily="49" charset="0"/>
              </a:rPr>
              <a:t>1C1Z:A|PDBID|CHAIN|SEQUENCE</a:t>
            </a:r>
          </a:p>
        </p:txBody>
      </p:sp>
      <p:pic>
        <p:nvPicPr>
          <p:cNvPr id="7175" name="Picture 7" descr="Suppl-Fig-X-blast2.jpg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04800" y="2362200"/>
            <a:ext cx="6400800" cy="298291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extBox 1"/>
          <p:cNvSpPr txBox="1">
            <a:spLocks noChangeArrowheads="1"/>
          </p:cNvSpPr>
          <p:nvPr/>
        </p:nvSpPr>
        <p:spPr bwMode="auto">
          <a:xfrm>
            <a:off x="3581400" y="6488113"/>
            <a:ext cx="2743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b="1" dirty="0">
                <a:latin typeface="Calibri" pitchFamily="34" charset="0"/>
              </a:rPr>
              <a:t>Supplementary Figure </a:t>
            </a:r>
            <a:r>
              <a:rPr lang="en-US" altLang="en-US" b="1" dirty="0" smtClean="0">
                <a:latin typeface="Calibri" pitchFamily="34" charset="0"/>
              </a:rPr>
              <a:t>7</a:t>
            </a:r>
            <a:endParaRPr lang="en-US" altLang="en-US" b="1" dirty="0">
              <a:latin typeface="Calibri" pitchFamily="34" charset="0"/>
            </a:endParaRPr>
          </a:p>
        </p:txBody>
      </p:sp>
      <p:pic>
        <p:nvPicPr>
          <p:cNvPr id="8195" name="Picture 2" descr="Cis-14-hydroxy-10_1bwo.png"/>
          <p:cNvPicPr>
            <a:picLocks noChangeAspect="1"/>
          </p:cNvPicPr>
          <p:nvPr/>
        </p:nvPicPr>
        <p:blipFill>
          <a:blip r:embed="rId2" cstate="print"/>
          <a:srcRect l="9375" r="12500"/>
          <a:stretch>
            <a:fillRect/>
          </a:stretch>
        </p:blipFill>
        <p:spPr bwMode="auto">
          <a:xfrm>
            <a:off x="152400" y="9525"/>
            <a:ext cx="5257800" cy="4719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196" name="Picture 3" descr="Cis-14-hydroxy-10_1mid.png"/>
          <p:cNvPicPr>
            <a:picLocks noChangeAspect="1"/>
          </p:cNvPicPr>
          <p:nvPr/>
        </p:nvPicPr>
        <p:blipFill>
          <a:blip r:embed="rId3" cstate="print"/>
          <a:srcRect l="14719" r="21875"/>
          <a:stretch>
            <a:fillRect/>
          </a:stretch>
        </p:blipFill>
        <p:spPr bwMode="auto">
          <a:xfrm>
            <a:off x="5410200" y="9525"/>
            <a:ext cx="4267200" cy="4719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197" name="TextBox 4"/>
          <p:cNvSpPr txBox="1">
            <a:spLocks noChangeArrowheads="1"/>
          </p:cNvSpPr>
          <p:nvPr/>
        </p:nvSpPr>
        <p:spPr bwMode="auto">
          <a:xfrm>
            <a:off x="3429000" y="3021013"/>
            <a:ext cx="6985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>
                <a:latin typeface="Calibri" pitchFamily="34" charset="0"/>
              </a:rPr>
              <a:t>Asp 7</a:t>
            </a:r>
          </a:p>
        </p:txBody>
      </p:sp>
      <p:sp>
        <p:nvSpPr>
          <p:cNvPr id="8198" name="TextBox 5"/>
          <p:cNvSpPr txBox="1">
            <a:spLocks noChangeArrowheads="1"/>
          </p:cNvSpPr>
          <p:nvPr/>
        </p:nvSpPr>
        <p:spPr bwMode="auto">
          <a:xfrm>
            <a:off x="8464550" y="2944813"/>
            <a:ext cx="6985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>
                <a:latin typeface="Calibri" pitchFamily="34" charset="0"/>
              </a:rPr>
              <a:t>Asp 7</a:t>
            </a:r>
          </a:p>
        </p:txBody>
      </p:sp>
      <p:sp>
        <p:nvSpPr>
          <p:cNvPr id="8199" name="TextBox 6"/>
          <p:cNvSpPr txBox="1">
            <a:spLocks noChangeArrowheads="1"/>
          </p:cNvSpPr>
          <p:nvPr/>
        </p:nvSpPr>
        <p:spPr bwMode="auto">
          <a:xfrm>
            <a:off x="7315200" y="4049713"/>
            <a:ext cx="6985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>
                <a:latin typeface="Calibri" pitchFamily="34" charset="0"/>
              </a:rPr>
              <a:t>1MID</a:t>
            </a:r>
          </a:p>
        </p:txBody>
      </p:sp>
      <p:sp>
        <p:nvSpPr>
          <p:cNvPr id="8200" name="TextBox 7"/>
          <p:cNvSpPr txBox="1">
            <a:spLocks noChangeArrowheads="1"/>
          </p:cNvSpPr>
          <p:nvPr/>
        </p:nvSpPr>
        <p:spPr bwMode="auto">
          <a:xfrm>
            <a:off x="2209800" y="4049713"/>
            <a:ext cx="779463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altLang="en-US">
                <a:latin typeface="Calibri" pitchFamily="34" charset="0"/>
              </a:rPr>
              <a:t>1BWO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Box 2"/>
          <p:cNvSpPr txBox="1">
            <a:spLocks noChangeArrowheads="1"/>
          </p:cNvSpPr>
          <p:nvPr/>
        </p:nvSpPr>
        <p:spPr bwMode="auto">
          <a:xfrm>
            <a:off x="3581400" y="6488113"/>
            <a:ext cx="2743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b="1" dirty="0">
                <a:latin typeface="Calibri" pitchFamily="34" charset="0"/>
              </a:rPr>
              <a:t>Supplementary Figure 8</a:t>
            </a:r>
          </a:p>
        </p:txBody>
      </p:sp>
      <p:pic>
        <p:nvPicPr>
          <p:cNvPr id="3075" name="Picture 4" descr="Cys)-cysteine_adduct-3dwg.png"/>
          <p:cNvPicPr>
            <a:picLocks noChangeAspect="1"/>
          </p:cNvPicPr>
          <p:nvPr/>
        </p:nvPicPr>
        <p:blipFill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 l="16220" t="9639" r="22066" b="9398"/>
          <a:stretch>
            <a:fillRect/>
          </a:stretch>
        </p:blipFill>
        <p:spPr bwMode="auto">
          <a:xfrm>
            <a:off x="228600" y="3276600"/>
            <a:ext cx="2971800" cy="273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6" name="TextBox 5"/>
          <p:cNvSpPr txBox="1">
            <a:spLocks noChangeArrowheads="1"/>
          </p:cNvSpPr>
          <p:nvPr/>
        </p:nvSpPr>
        <p:spPr bwMode="auto">
          <a:xfrm>
            <a:off x="1041400" y="5943600"/>
            <a:ext cx="13462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en-US">
                <a:latin typeface="Calibri" pitchFamily="34" charset="0"/>
              </a:rPr>
              <a:t>(b)  3DWG:C</a:t>
            </a:r>
          </a:p>
        </p:txBody>
      </p:sp>
      <p:pic>
        <p:nvPicPr>
          <p:cNvPr id="3077" name="Picture 6" descr="5glutamyl_-3vpdE.png"/>
          <p:cNvPicPr>
            <a:picLocks noChangeAspect="1"/>
          </p:cNvPicPr>
          <p:nvPr/>
        </p:nvPicPr>
        <p:blipFill>
          <a:blip r:embed="rId3" cstate="print"/>
          <a:srcRect l="12895" t="2791" r="15260" b="10509"/>
          <a:stretch>
            <a:fillRect/>
          </a:stretch>
        </p:blipFill>
        <p:spPr bwMode="auto">
          <a:xfrm>
            <a:off x="319088" y="228600"/>
            <a:ext cx="2790825" cy="2362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8" name="TextBox 7"/>
          <p:cNvSpPr txBox="1">
            <a:spLocks noChangeArrowheads="1"/>
          </p:cNvSpPr>
          <p:nvPr/>
        </p:nvSpPr>
        <p:spPr bwMode="auto">
          <a:xfrm>
            <a:off x="1109663" y="2754313"/>
            <a:ext cx="1209675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en-US">
                <a:latin typeface="Calibri" pitchFamily="34" charset="0"/>
              </a:rPr>
              <a:t>(a)  3VPB:E</a:t>
            </a:r>
          </a:p>
        </p:txBody>
      </p:sp>
      <p:pic>
        <p:nvPicPr>
          <p:cNvPr id="3079" name="Picture 8" descr="leucine_methyl_ester-3p71C_v2.png"/>
          <p:cNvPicPr>
            <a:picLocks noChangeAspect="1"/>
          </p:cNvPicPr>
          <p:nvPr/>
        </p:nvPicPr>
        <p:blipFill>
          <a:blip r:embed="rId4" cstate="print"/>
          <a:srcRect l="7405" t="13200" r="9286" b="12871"/>
          <a:stretch>
            <a:fillRect/>
          </a:stretch>
        </p:blipFill>
        <p:spPr bwMode="auto">
          <a:xfrm>
            <a:off x="3429000" y="3624263"/>
            <a:ext cx="3429000" cy="2133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80" name="TextBox 9"/>
          <p:cNvSpPr txBox="1">
            <a:spLocks noChangeArrowheads="1"/>
          </p:cNvSpPr>
          <p:nvPr/>
        </p:nvSpPr>
        <p:spPr bwMode="auto">
          <a:xfrm>
            <a:off x="4538663" y="5943600"/>
            <a:ext cx="120967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en-US">
                <a:latin typeface="Calibri" pitchFamily="34" charset="0"/>
              </a:rPr>
              <a:t>(d)  3P71:C</a:t>
            </a:r>
          </a:p>
        </p:txBody>
      </p:sp>
      <p:pic>
        <p:nvPicPr>
          <p:cNvPr id="3081" name="Picture 10" descr="leucine_methyl_ester-3c5w.png"/>
          <p:cNvPicPr>
            <a:picLocks noChangeAspect="1"/>
          </p:cNvPicPr>
          <p:nvPr/>
        </p:nvPicPr>
        <p:blipFill>
          <a:blip r:embed="rId5" cstate="print"/>
          <a:srcRect l="15318" t="9091" r="22533" b="9091"/>
          <a:stretch>
            <a:fillRect/>
          </a:stretch>
        </p:blipFill>
        <p:spPr bwMode="auto">
          <a:xfrm>
            <a:off x="3733800" y="141288"/>
            <a:ext cx="2819400" cy="260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82" name="TextBox 11"/>
          <p:cNvSpPr txBox="1">
            <a:spLocks noChangeArrowheads="1"/>
          </p:cNvSpPr>
          <p:nvPr/>
        </p:nvSpPr>
        <p:spPr bwMode="auto">
          <a:xfrm>
            <a:off x="4505325" y="2754313"/>
            <a:ext cx="127635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en-US">
                <a:latin typeface="Calibri" pitchFamily="34" charset="0"/>
              </a:rPr>
              <a:t>(c)  3C5W:C</a:t>
            </a:r>
          </a:p>
        </p:txBody>
      </p:sp>
      <p:pic>
        <p:nvPicPr>
          <p:cNvPr id="3083" name="Picture 12" descr="glycyl-adenylate-1fm0.png"/>
          <p:cNvPicPr>
            <a:picLocks noChangeAspect="1"/>
          </p:cNvPicPr>
          <p:nvPr/>
        </p:nvPicPr>
        <p:blipFill>
          <a:blip r:embed="rId6" cstate="print"/>
          <a:srcRect l="17188" t="8914" r="18750"/>
          <a:stretch>
            <a:fillRect/>
          </a:stretch>
        </p:blipFill>
        <p:spPr bwMode="auto">
          <a:xfrm>
            <a:off x="6956425" y="76200"/>
            <a:ext cx="2827338" cy="2819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4" name="Picture 13" descr="glycyl-adenylate-1zud.png"/>
          <p:cNvPicPr>
            <a:picLocks noChangeAspect="1"/>
          </p:cNvPicPr>
          <p:nvPr/>
        </p:nvPicPr>
        <p:blipFill>
          <a:blip r:embed="rId7" cstate="print"/>
          <a:srcRect l="20313" r="14063" b="8635"/>
          <a:stretch>
            <a:fillRect/>
          </a:stretch>
        </p:blipFill>
        <p:spPr bwMode="auto">
          <a:xfrm>
            <a:off x="7081838" y="3505200"/>
            <a:ext cx="2576512" cy="2514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85" name="TextBox 14"/>
          <p:cNvSpPr txBox="1">
            <a:spLocks noChangeArrowheads="1"/>
          </p:cNvSpPr>
          <p:nvPr/>
        </p:nvSpPr>
        <p:spPr bwMode="auto">
          <a:xfrm>
            <a:off x="7726363" y="2754313"/>
            <a:ext cx="128905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en-US">
                <a:latin typeface="Calibri" pitchFamily="34" charset="0"/>
              </a:rPr>
              <a:t>(e)  1FM0:D</a:t>
            </a:r>
          </a:p>
        </p:txBody>
      </p:sp>
      <p:sp>
        <p:nvSpPr>
          <p:cNvPr id="3086" name="TextBox 15"/>
          <p:cNvSpPr txBox="1">
            <a:spLocks noChangeArrowheads="1"/>
          </p:cNvSpPr>
          <p:nvPr/>
        </p:nvSpPr>
        <p:spPr bwMode="auto">
          <a:xfrm>
            <a:off x="7770813" y="5943600"/>
            <a:ext cx="1198562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en-US">
                <a:latin typeface="Calibri" pitchFamily="34" charset="0"/>
              </a:rPr>
              <a:t>(f)  1ZUD:2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extBox 1"/>
          <p:cNvSpPr txBox="1">
            <a:spLocks noChangeArrowheads="1"/>
          </p:cNvSpPr>
          <p:nvPr/>
        </p:nvSpPr>
        <p:spPr bwMode="auto">
          <a:xfrm>
            <a:off x="3581400" y="6488113"/>
            <a:ext cx="27432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en-US" b="1" dirty="0">
                <a:latin typeface="Calibri" pitchFamily="34" charset="0"/>
              </a:rPr>
              <a:t>Supplementary Figure </a:t>
            </a:r>
            <a:r>
              <a:rPr lang="en-US" altLang="en-US" b="1" dirty="0" smtClean="0">
                <a:latin typeface="Calibri" pitchFamily="34" charset="0"/>
              </a:rPr>
              <a:t>9</a:t>
            </a:r>
            <a:endParaRPr lang="en-US" altLang="en-US" b="1" dirty="0">
              <a:latin typeface="Calibri" pitchFamily="34" charset="0"/>
            </a:endParaRPr>
          </a:p>
        </p:txBody>
      </p:sp>
      <p:grpSp>
        <p:nvGrpSpPr>
          <p:cNvPr id="9219" name="Group 16"/>
          <p:cNvGrpSpPr>
            <a:grpSpLocks/>
          </p:cNvGrpSpPr>
          <p:nvPr/>
        </p:nvGrpSpPr>
        <p:grpSpPr bwMode="auto">
          <a:xfrm>
            <a:off x="376238" y="533400"/>
            <a:ext cx="9153525" cy="5495925"/>
            <a:chOff x="376237" y="533400"/>
            <a:chExt cx="9153525" cy="5495925"/>
          </a:xfrm>
        </p:grpSpPr>
        <p:graphicFrame>
          <p:nvGraphicFramePr>
            <p:cNvPr id="10" name="Chart 9"/>
            <p:cNvGraphicFramePr/>
            <p:nvPr/>
          </p:nvGraphicFramePr>
          <p:xfrm>
            <a:off x="376237" y="5334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1" name="Chart 10"/>
            <p:cNvGraphicFramePr/>
            <p:nvPr/>
          </p:nvGraphicFramePr>
          <p:xfrm>
            <a:off x="4957762" y="5334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2" name="Chart 11"/>
            <p:cNvGraphicFramePr/>
            <p:nvPr/>
          </p:nvGraphicFramePr>
          <p:xfrm>
            <a:off x="376237" y="3286125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3" name="Chart 12"/>
            <p:cNvGraphicFramePr/>
            <p:nvPr/>
          </p:nvGraphicFramePr>
          <p:xfrm>
            <a:off x="4957762" y="3286125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9224" name="TextBox 7"/>
            <p:cNvSpPr txBox="1">
              <a:spLocks noChangeArrowheads="1"/>
            </p:cNvSpPr>
            <p:nvPr/>
          </p:nvSpPr>
          <p:spPr bwMode="auto">
            <a:xfrm>
              <a:off x="376237" y="533400"/>
              <a:ext cx="444352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SG" altLang="en-US">
                  <a:latin typeface="Calibri" pitchFamily="34" charset="0"/>
                </a:rPr>
                <a:t>(</a:t>
              </a:r>
              <a:r>
                <a:rPr lang="en-SG" altLang="en-US" i="1">
                  <a:latin typeface="Cambria" pitchFamily="18" charset="0"/>
                </a:rPr>
                <a:t>a</a:t>
              </a:r>
              <a:r>
                <a:rPr lang="en-SG" altLang="en-US">
                  <a:latin typeface="Calibri" pitchFamily="34" charset="0"/>
                </a:rPr>
                <a:t>)</a:t>
              </a:r>
              <a:endParaRPr lang="en-US" altLang="en-US">
                <a:latin typeface="Calibri" pitchFamily="34" charset="0"/>
              </a:endParaRPr>
            </a:p>
          </p:txBody>
        </p:sp>
        <p:sp>
          <p:nvSpPr>
            <p:cNvPr id="9225" name="TextBox 13"/>
            <p:cNvSpPr txBox="1">
              <a:spLocks noChangeArrowheads="1"/>
            </p:cNvSpPr>
            <p:nvPr/>
          </p:nvSpPr>
          <p:spPr bwMode="auto">
            <a:xfrm>
              <a:off x="4957762" y="3286125"/>
              <a:ext cx="445956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SG" altLang="en-US">
                  <a:latin typeface="Calibri" pitchFamily="34" charset="0"/>
                </a:rPr>
                <a:t>(</a:t>
              </a:r>
              <a:r>
                <a:rPr lang="en-SG" altLang="en-US" i="1">
                  <a:latin typeface="Cambria" pitchFamily="18" charset="0"/>
                </a:rPr>
                <a:t>d</a:t>
              </a:r>
              <a:r>
                <a:rPr lang="en-SG" altLang="en-US">
                  <a:latin typeface="Calibri" pitchFamily="34" charset="0"/>
                </a:rPr>
                <a:t>)</a:t>
              </a:r>
              <a:endParaRPr lang="en-US" altLang="en-US">
                <a:latin typeface="Calibri" pitchFamily="34" charset="0"/>
              </a:endParaRPr>
            </a:p>
          </p:txBody>
        </p:sp>
        <p:sp>
          <p:nvSpPr>
            <p:cNvPr id="9226" name="TextBox 14"/>
            <p:cNvSpPr txBox="1">
              <a:spLocks noChangeArrowheads="1"/>
            </p:cNvSpPr>
            <p:nvPr/>
          </p:nvSpPr>
          <p:spPr bwMode="auto">
            <a:xfrm>
              <a:off x="4957762" y="533400"/>
              <a:ext cx="444352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SG" altLang="en-US">
                  <a:latin typeface="Calibri" pitchFamily="34" charset="0"/>
                </a:rPr>
                <a:t>(</a:t>
              </a:r>
              <a:r>
                <a:rPr lang="en-SG" altLang="en-US" i="1">
                  <a:latin typeface="Cambria" pitchFamily="18" charset="0"/>
                </a:rPr>
                <a:t>b</a:t>
              </a:r>
              <a:r>
                <a:rPr lang="en-SG" altLang="en-US">
                  <a:latin typeface="Calibri" pitchFamily="34" charset="0"/>
                </a:rPr>
                <a:t>)</a:t>
              </a:r>
              <a:endParaRPr lang="en-US" altLang="en-US">
                <a:latin typeface="Calibri" pitchFamily="34" charset="0"/>
              </a:endParaRPr>
            </a:p>
          </p:txBody>
        </p:sp>
        <p:sp>
          <p:nvSpPr>
            <p:cNvPr id="9227" name="TextBox 15"/>
            <p:cNvSpPr txBox="1">
              <a:spLocks noChangeArrowheads="1"/>
            </p:cNvSpPr>
            <p:nvPr/>
          </p:nvSpPr>
          <p:spPr bwMode="auto">
            <a:xfrm>
              <a:off x="376237" y="3286125"/>
              <a:ext cx="425116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SG" altLang="en-US">
                  <a:latin typeface="Calibri" pitchFamily="34" charset="0"/>
                </a:rPr>
                <a:t>(</a:t>
              </a:r>
              <a:r>
                <a:rPr lang="en-SG" altLang="en-US" i="1">
                  <a:latin typeface="Cambria" pitchFamily="18" charset="0"/>
                </a:rPr>
                <a:t>c</a:t>
              </a:r>
              <a:r>
                <a:rPr lang="en-SG" altLang="en-US">
                  <a:latin typeface="Calibri" pitchFamily="34" charset="0"/>
                </a:rPr>
                <a:t>)</a:t>
              </a:r>
              <a:endParaRPr lang="en-US" altLang="en-US">
                <a:latin typeface="Calibri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4</Words>
  <Application>Microsoft Office PowerPoint</Application>
  <PresentationFormat>A4-Papier (210x297 mm)</PresentationFormat>
  <Paragraphs>56</Paragraphs>
  <Slides>1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3</vt:i4>
      </vt:variant>
    </vt:vector>
  </HeadingPairs>
  <TitlesOfParts>
    <vt:vector size="14" baseType="lpstr"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ernanda</dc:creator>
  <cp:lastModifiedBy>Wolter, Fay - Weinheim</cp:lastModifiedBy>
  <cp:revision>1943</cp:revision>
  <dcterms:created xsi:type="dcterms:W3CDTF">2014-06-04T01:39:22Z</dcterms:created>
  <dcterms:modified xsi:type="dcterms:W3CDTF">2015-05-19T08:23:39Z</dcterms:modified>
</cp:coreProperties>
</file>